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2" r:id="rId6"/>
    <p:sldId id="261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-1832" y="1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rannona:Documents:MSKCC:Colon%20here:colon_FFPE_summary_201404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2400"/>
            </a:pPr>
            <a:r>
              <a:rPr lang="en-US" sz="2400"/>
              <a:t>Allele Frequenc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Shared Mutations</c:v>
          </c:tx>
          <c:spPr>
            <a:ln w="47625">
              <a:noFill/>
            </a:ln>
          </c:spPr>
          <c:marker>
            <c:symbol val="circle"/>
            <c:size val="6"/>
            <c:spPr>
              <a:solidFill>
                <a:schemeClr val="accent4">
                  <a:lumMod val="75000"/>
                </a:schemeClr>
              </a:solidFill>
              <a:ln>
                <a:solidFill>
                  <a:schemeClr val="accent4">
                    <a:lumMod val="50000"/>
                  </a:schemeClr>
                </a:solidFill>
              </a:ln>
            </c:spPr>
          </c:marker>
          <c:xVal>
            <c:numRef>
              <c:f>Sheet1!$C$2:$C$435</c:f>
              <c:numCache>
                <c:formatCode>General</c:formatCode>
                <c:ptCount val="434"/>
                <c:pt idx="0">
                  <c:v>0.04141</c:v>
                </c:pt>
                <c:pt idx="1">
                  <c:v>0.05051</c:v>
                </c:pt>
                <c:pt idx="2">
                  <c:v>0.05164</c:v>
                </c:pt>
                <c:pt idx="3">
                  <c:v>0.05347</c:v>
                </c:pt>
                <c:pt idx="4">
                  <c:v>0.05373</c:v>
                </c:pt>
                <c:pt idx="5">
                  <c:v>0.05946</c:v>
                </c:pt>
                <c:pt idx="6">
                  <c:v>0.06163</c:v>
                </c:pt>
                <c:pt idx="7">
                  <c:v>0.06203</c:v>
                </c:pt>
                <c:pt idx="8">
                  <c:v>0.07507</c:v>
                </c:pt>
                <c:pt idx="9">
                  <c:v>0.08626</c:v>
                </c:pt>
                <c:pt idx="10">
                  <c:v>0.08629</c:v>
                </c:pt>
                <c:pt idx="11">
                  <c:v>0.08706</c:v>
                </c:pt>
                <c:pt idx="12">
                  <c:v>0.09113</c:v>
                </c:pt>
                <c:pt idx="13">
                  <c:v>0.09412</c:v>
                </c:pt>
                <c:pt idx="14">
                  <c:v>0.09496</c:v>
                </c:pt>
                <c:pt idx="15">
                  <c:v>0.12346</c:v>
                </c:pt>
                <c:pt idx="16">
                  <c:v>0.1345</c:v>
                </c:pt>
                <c:pt idx="17">
                  <c:v>0.17078</c:v>
                </c:pt>
                <c:pt idx="18">
                  <c:v>0.18056</c:v>
                </c:pt>
                <c:pt idx="19">
                  <c:v>0.18542</c:v>
                </c:pt>
                <c:pt idx="20">
                  <c:v>0.18644</c:v>
                </c:pt>
                <c:pt idx="21">
                  <c:v>0.215</c:v>
                </c:pt>
                <c:pt idx="22">
                  <c:v>0.21883</c:v>
                </c:pt>
                <c:pt idx="23">
                  <c:v>0.28336</c:v>
                </c:pt>
                <c:pt idx="24">
                  <c:v>0.28794</c:v>
                </c:pt>
                <c:pt idx="25">
                  <c:v>0.28814</c:v>
                </c:pt>
                <c:pt idx="26">
                  <c:v>0.29331</c:v>
                </c:pt>
                <c:pt idx="27">
                  <c:v>0.31429</c:v>
                </c:pt>
                <c:pt idx="28">
                  <c:v>0.35994</c:v>
                </c:pt>
                <c:pt idx="29">
                  <c:v>0.4376</c:v>
                </c:pt>
                <c:pt idx="30">
                  <c:v>0.53008</c:v>
                </c:pt>
                <c:pt idx="31">
                  <c:v>0.55236</c:v>
                </c:pt>
                <c:pt idx="32">
                  <c:v>0.27101</c:v>
                </c:pt>
                <c:pt idx="33">
                  <c:v>0.07298</c:v>
                </c:pt>
                <c:pt idx="34">
                  <c:v>0.12541</c:v>
                </c:pt>
                <c:pt idx="35">
                  <c:v>0.09327</c:v>
                </c:pt>
                <c:pt idx="36">
                  <c:v>0.12667</c:v>
                </c:pt>
                <c:pt idx="37">
                  <c:v>0.13084</c:v>
                </c:pt>
                <c:pt idx="38">
                  <c:v>0.19682</c:v>
                </c:pt>
                <c:pt idx="39">
                  <c:v>0.20497</c:v>
                </c:pt>
                <c:pt idx="40">
                  <c:v>0.053</c:v>
                </c:pt>
                <c:pt idx="41">
                  <c:v>0.14082</c:v>
                </c:pt>
                <c:pt idx="42">
                  <c:v>0.19668</c:v>
                </c:pt>
                <c:pt idx="43">
                  <c:v>0.14019</c:v>
                </c:pt>
                <c:pt idx="44">
                  <c:v>0.27094</c:v>
                </c:pt>
                <c:pt idx="45">
                  <c:v>0.23973</c:v>
                </c:pt>
                <c:pt idx="46">
                  <c:v>0.1994</c:v>
                </c:pt>
                <c:pt idx="47">
                  <c:v>0.2381</c:v>
                </c:pt>
                <c:pt idx="48">
                  <c:v>0.12247</c:v>
                </c:pt>
                <c:pt idx="49">
                  <c:v>0.13418</c:v>
                </c:pt>
                <c:pt idx="50">
                  <c:v>0.16616</c:v>
                </c:pt>
                <c:pt idx="51">
                  <c:v>0.21053</c:v>
                </c:pt>
                <c:pt idx="52">
                  <c:v>0.20134</c:v>
                </c:pt>
                <c:pt idx="53">
                  <c:v>0.2043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7414</c:v>
                </c:pt>
                <c:pt idx="58">
                  <c:v>0.23709</c:v>
                </c:pt>
                <c:pt idx="59">
                  <c:v>0.0</c:v>
                </c:pt>
                <c:pt idx="60">
                  <c:v>0.02391</c:v>
                </c:pt>
                <c:pt idx="61">
                  <c:v>0.1657</c:v>
                </c:pt>
                <c:pt idx="62">
                  <c:v>0.14444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30986</c:v>
                </c:pt>
                <c:pt idx="69">
                  <c:v>0.38723</c:v>
                </c:pt>
                <c:pt idx="70">
                  <c:v>0.08459</c:v>
                </c:pt>
                <c:pt idx="71">
                  <c:v>0.00249</c:v>
                </c:pt>
                <c:pt idx="72">
                  <c:v>0.10238</c:v>
                </c:pt>
                <c:pt idx="73">
                  <c:v>0.29637</c:v>
                </c:pt>
                <c:pt idx="74">
                  <c:v>0.41535</c:v>
                </c:pt>
                <c:pt idx="75">
                  <c:v>0.15916</c:v>
                </c:pt>
                <c:pt idx="76">
                  <c:v>0.10013</c:v>
                </c:pt>
                <c:pt idx="77">
                  <c:v>0.00151</c:v>
                </c:pt>
                <c:pt idx="78">
                  <c:v>0.0</c:v>
                </c:pt>
                <c:pt idx="79">
                  <c:v>0.14105</c:v>
                </c:pt>
                <c:pt idx="80">
                  <c:v>0.13049</c:v>
                </c:pt>
                <c:pt idx="81">
                  <c:v>0.20021</c:v>
                </c:pt>
                <c:pt idx="82">
                  <c:v>0.34278</c:v>
                </c:pt>
                <c:pt idx="83">
                  <c:v>0.0</c:v>
                </c:pt>
                <c:pt idx="84">
                  <c:v>0.40599</c:v>
                </c:pt>
                <c:pt idx="85">
                  <c:v>0.10246</c:v>
                </c:pt>
                <c:pt idx="86">
                  <c:v>0.22075</c:v>
                </c:pt>
                <c:pt idx="87">
                  <c:v>0.11872</c:v>
                </c:pt>
                <c:pt idx="88">
                  <c:v>0.0494</c:v>
                </c:pt>
                <c:pt idx="89">
                  <c:v>0.16172</c:v>
                </c:pt>
                <c:pt idx="90">
                  <c:v>0.33333</c:v>
                </c:pt>
                <c:pt idx="91">
                  <c:v>0.409</c:v>
                </c:pt>
                <c:pt idx="92">
                  <c:v>0.0</c:v>
                </c:pt>
                <c:pt idx="93">
                  <c:v>0.13622</c:v>
                </c:pt>
                <c:pt idx="94">
                  <c:v>0.40923</c:v>
                </c:pt>
                <c:pt idx="95">
                  <c:v>0.12247</c:v>
                </c:pt>
                <c:pt idx="96">
                  <c:v>0.0</c:v>
                </c:pt>
                <c:pt idx="97">
                  <c:v>0.19159</c:v>
                </c:pt>
                <c:pt idx="98">
                  <c:v>0.09418</c:v>
                </c:pt>
                <c:pt idx="99">
                  <c:v>0.14286</c:v>
                </c:pt>
                <c:pt idx="100">
                  <c:v>0.14956</c:v>
                </c:pt>
                <c:pt idx="101">
                  <c:v>0.27215</c:v>
                </c:pt>
                <c:pt idx="102">
                  <c:v>0.0</c:v>
                </c:pt>
                <c:pt idx="103">
                  <c:v>0.05466</c:v>
                </c:pt>
                <c:pt idx="104">
                  <c:v>0.07952</c:v>
                </c:pt>
                <c:pt idx="105">
                  <c:v>0.28313</c:v>
                </c:pt>
                <c:pt idx="106">
                  <c:v>0.28883</c:v>
                </c:pt>
                <c:pt idx="107">
                  <c:v>0.09948</c:v>
                </c:pt>
                <c:pt idx="108">
                  <c:v>0.0</c:v>
                </c:pt>
                <c:pt idx="109">
                  <c:v>0.25509</c:v>
                </c:pt>
                <c:pt idx="110">
                  <c:v>0.17355</c:v>
                </c:pt>
                <c:pt idx="111">
                  <c:v>0.0</c:v>
                </c:pt>
                <c:pt idx="112">
                  <c:v>0.4359</c:v>
                </c:pt>
                <c:pt idx="113">
                  <c:v>0.00328</c:v>
                </c:pt>
                <c:pt idx="114">
                  <c:v>0.17115</c:v>
                </c:pt>
                <c:pt idx="115">
                  <c:v>0.11296</c:v>
                </c:pt>
                <c:pt idx="116">
                  <c:v>0.1223</c:v>
                </c:pt>
                <c:pt idx="117">
                  <c:v>0.12906</c:v>
                </c:pt>
                <c:pt idx="118">
                  <c:v>0.29265</c:v>
                </c:pt>
                <c:pt idx="119">
                  <c:v>0.28077</c:v>
                </c:pt>
                <c:pt idx="120">
                  <c:v>0.20598</c:v>
                </c:pt>
                <c:pt idx="121">
                  <c:v>0.0</c:v>
                </c:pt>
                <c:pt idx="122">
                  <c:v>0.0</c:v>
                </c:pt>
                <c:pt idx="123">
                  <c:v>0.46667</c:v>
                </c:pt>
                <c:pt idx="124">
                  <c:v>0.15328</c:v>
                </c:pt>
                <c:pt idx="125">
                  <c:v>0.11158</c:v>
                </c:pt>
                <c:pt idx="126">
                  <c:v>0.12039</c:v>
                </c:pt>
                <c:pt idx="127">
                  <c:v>0.23007</c:v>
                </c:pt>
                <c:pt idx="128">
                  <c:v>0.48764</c:v>
                </c:pt>
                <c:pt idx="129">
                  <c:v>0.22486</c:v>
                </c:pt>
                <c:pt idx="130">
                  <c:v>0.28438</c:v>
                </c:pt>
                <c:pt idx="131">
                  <c:v>0.21073</c:v>
                </c:pt>
                <c:pt idx="132">
                  <c:v>0.21654</c:v>
                </c:pt>
                <c:pt idx="133">
                  <c:v>0.23408</c:v>
                </c:pt>
                <c:pt idx="134">
                  <c:v>0.23087</c:v>
                </c:pt>
                <c:pt idx="135">
                  <c:v>0.24041</c:v>
                </c:pt>
                <c:pt idx="136">
                  <c:v>0.11605</c:v>
                </c:pt>
                <c:pt idx="137">
                  <c:v>0.18878</c:v>
                </c:pt>
                <c:pt idx="138">
                  <c:v>0.17411</c:v>
                </c:pt>
                <c:pt idx="139">
                  <c:v>0.00301</c:v>
                </c:pt>
                <c:pt idx="140">
                  <c:v>0.27451</c:v>
                </c:pt>
                <c:pt idx="141">
                  <c:v>0.0</c:v>
                </c:pt>
                <c:pt idx="142">
                  <c:v>0.06383</c:v>
                </c:pt>
                <c:pt idx="143">
                  <c:v>0.18513</c:v>
                </c:pt>
                <c:pt idx="144">
                  <c:v>0.1189</c:v>
                </c:pt>
                <c:pt idx="145">
                  <c:v>0.0</c:v>
                </c:pt>
                <c:pt idx="146">
                  <c:v>0.21965</c:v>
                </c:pt>
                <c:pt idx="147">
                  <c:v>0.16667</c:v>
                </c:pt>
                <c:pt idx="148">
                  <c:v>0.16667</c:v>
                </c:pt>
                <c:pt idx="149">
                  <c:v>0.06691</c:v>
                </c:pt>
                <c:pt idx="150">
                  <c:v>0.12476</c:v>
                </c:pt>
                <c:pt idx="151">
                  <c:v>0.24078</c:v>
                </c:pt>
                <c:pt idx="152">
                  <c:v>0.36126</c:v>
                </c:pt>
                <c:pt idx="153">
                  <c:v>0.0</c:v>
                </c:pt>
                <c:pt idx="154">
                  <c:v>0.16722</c:v>
                </c:pt>
                <c:pt idx="155">
                  <c:v>0.02703</c:v>
                </c:pt>
                <c:pt idx="156">
                  <c:v>0.22865</c:v>
                </c:pt>
                <c:pt idx="157">
                  <c:v>0.30488</c:v>
                </c:pt>
                <c:pt idx="158">
                  <c:v>0.29044</c:v>
                </c:pt>
                <c:pt idx="159">
                  <c:v>0.0</c:v>
                </c:pt>
                <c:pt idx="160">
                  <c:v>0.1318</c:v>
                </c:pt>
                <c:pt idx="161">
                  <c:v>0.30472</c:v>
                </c:pt>
                <c:pt idx="162">
                  <c:v>0.03972</c:v>
                </c:pt>
                <c:pt idx="163">
                  <c:v>0.11491</c:v>
                </c:pt>
                <c:pt idx="164">
                  <c:v>0.15841</c:v>
                </c:pt>
                <c:pt idx="165">
                  <c:v>0.16253</c:v>
                </c:pt>
                <c:pt idx="166">
                  <c:v>0.0</c:v>
                </c:pt>
                <c:pt idx="167">
                  <c:v>0.33896</c:v>
                </c:pt>
                <c:pt idx="168">
                  <c:v>0.18218</c:v>
                </c:pt>
                <c:pt idx="169">
                  <c:v>0.22241</c:v>
                </c:pt>
                <c:pt idx="170">
                  <c:v>0.27441</c:v>
                </c:pt>
                <c:pt idx="171">
                  <c:v>0.0</c:v>
                </c:pt>
                <c:pt idx="172">
                  <c:v>0.19024</c:v>
                </c:pt>
                <c:pt idx="173">
                  <c:v>0.21888</c:v>
                </c:pt>
                <c:pt idx="174">
                  <c:v>0.11051</c:v>
                </c:pt>
                <c:pt idx="175">
                  <c:v>0.20493</c:v>
                </c:pt>
                <c:pt idx="176">
                  <c:v>0.21429</c:v>
                </c:pt>
                <c:pt idx="177">
                  <c:v>0.09677</c:v>
                </c:pt>
                <c:pt idx="178">
                  <c:v>0.05743</c:v>
                </c:pt>
                <c:pt idx="179">
                  <c:v>0.2577</c:v>
                </c:pt>
                <c:pt idx="180">
                  <c:v>0.08462</c:v>
                </c:pt>
                <c:pt idx="181">
                  <c:v>0.21629</c:v>
                </c:pt>
                <c:pt idx="182">
                  <c:v>0.20524</c:v>
                </c:pt>
                <c:pt idx="183">
                  <c:v>0.0</c:v>
                </c:pt>
                <c:pt idx="184">
                  <c:v>0.05977</c:v>
                </c:pt>
                <c:pt idx="185">
                  <c:v>0.18047</c:v>
                </c:pt>
                <c:pt idx="186">
                  <c:v>0.12136</c:v>
                </c:pt>
                <c:pt idx="187">
                  <c:v>0.1274</c:v>
                </c:pt>
                <c:pt idx="188">
                  <c:v>0.29027</c:v>
                </c:pt>
                <c:pt idx="189">
                  <c:v>0.21145</c:v>
                </c:pt>
                <c:pt idx="190">
                  <c:v>0.22555</c:v>
                </c:pt>
                <c:pt idx="191">
                  <c:v>0.30576</c:v>
                </c:pt>
                <c:pt idx="192">
                  <c:v>0.2082</c:v>
                </c:pt>
                <c:pt idx="193">
                  <c:v>0.12708</c:v>
                </c:pt>
                <c:pt idx="194">
                  <c:v>0.26092</c:v>
                </c:pt>
                <c:pt idx="195">
                  <c:v>0.24804</c:v>
                </c:pt>
                <c:pt idx="196">
                  <c:v>0.18685</c:v>
                </c:pt>
                <c:pt idx="197">
                  <c:v>0.35698</c:v>
                </c:pt>
                <c:pt idx="198">
                  <c:v>0.20513</c:v>
                </c:pt>
                <c:pt idx="199">
                  <c:v>0.20351</c:v>
                </c:pt>
                <c:pt idx="200">
                  <c:v>0.23617</c:v>
                </c:pt>
                <c:pt idx="201">
                  <c:v>0.16236</c:v>
                </c:pt>
                <c:pt idx="202">
                  <c:v>0.2226</c:v>
                </c:pt>
                <c:pt idx="203">
                  <c:v>0.246575342465753</c:v>
                </c:pt>
                <c:pt idx="204">
                  <c:v>0.27477</c:v>
                </c:pt>
                <c:pt idx="205">
                  <c:v>0.23016</c:v>
                </c:pt>
                <c:pt idx="206">
                  <c:v>0.26837</c:v>
                </c:pt>
                <c:pt idx="207">
                  <c:v>0.28442</c:v>
                </c:pt>
                <c:pt idx="208">
                  <c:v>0.29156</c:v>
                </c:pt>
                <c:pt idx="209">
                  <c:v>0.0</c:v>
                </c:pt>
                <c:pt idx="210">
                  <c:v>0.2877</c:v>
                </c:pt>
                <c:pt idx="211">
                  <c:v>0.27072</c:v>
                </c:pt>
                <c:pt idx="212">
                  <c:v>0.49143</c:v>
                </c:pt>
                <c:pt idx="213">
                  <c:v>0.13759</c:v>
                </c:pt>
                <c:pt idx="214">
                  <c:v>0.15933</c:v>
                </c:pt>
                <c:pt idx="215">
                  <c:v>0.11253</c:v>
                </c:pt>
                <c:pt idx="216">
                  <c:v>0.19693</c:v>
                </c:pt>
                <c:pt idx="217">
                  <c:v>0.19281</c:v>
                </c:pt>
                <c:pt idx="218">
                  <c:v>0.25473</c:v>
                </c:pt>
                <c:pt idx="219">
                  <c:v>0.25087</c:v>
                </c:pt>
                <c:pt idx="220">
                  <c:v>0.08108</c:v>
                </c:pt>
                <c:pt idx="221">
                  <c:v>0.23103</c:v>
                </c:pt>
                <c:pt idx="222">
                  <c:v>0.32296</c:v>
                </c:pt>
                <c:pt idx="223">
                  <c:v>0.15725</c:v>
                </c:pt>
                <c:pt idx="224">
                  <c:v>0.32133</c:v>
                </c:pt>
                <c:pt idx="225">
                  <c:v>0.14858</c:v>
                </c:pt>
                <c:pt idx="226">
                  <c:v>0.29429</c:v>
                </c:pt>
                <c:pt idx="227">
                  <c:v>0.13098</c:v>
                </c:pt>
                <c:pt idx="228">
                  <c:v>0.0914</c:v>
                </c:pt>
                <c:pt idx="229">
                  <c:v>0.34413</c:v>
                </c:pt>
                <c:pt idx="230">
                  <c:v>0.25894</c:v>
                </c:pt>
                <c:pt idx="231">
                  <c:v>0.24049</c:v>
                </c:pt>
                <c:pt idx="232">
                  <c:v>0.23077</c:v>
                </c:pt>
                <c:pt idx="233">
                  <c:v>0.01991</c:v>
                </c:pt>
                <c:pt idx="234">
                  <c:v>0.3902</c:v>
                </c:pt>
                <c:pt idx="235">
                  <c:v>0.0</c:v>
                </c:pt>
                <c:pt idx="236">
                  <c:v>0.0</c:v>
                </c:pt>
                <c:pt idx="237">
                  <c:v>0.13456</c:v>
                </c:pt>
                <c:pt idx="238">
                  <c:v>0.07864</c:v>
                </c:pt>
                <c:pt idx="239">
                  <c:v>0.26686</c:v>
                </c:pt>
                <c:pt idx="240">
                  <c:v>0.41379</c:v>
                </c:pt>
                <c:pt idx="241">
                  <c:v>0.13619</c:v>
                </c:pt>
                <c:pt idx="242">
                  <c:v>0.0</c:v>
                </c:pt>
                <c:pt idx="243">
                  <c:v>0.31637</c:v>
                </c:pt>
                <c:pt idx="244">
                  <c:v>0.29752</c:v>
                </c:pt>
                <c:pt idx="245">
                  <c:v>0.27273</c:v>
                </c:pt>
                <c:pt idx="246">
                  <c:v>0.24194</c:v>
                </c:pt>
                <c:pt idx="247">
                  <c:v>0.31991</c:v>
                </c:pt>
                <c:pt idx="248">
                  <c:v>0.24784</c:v>
                </c:pt>
                <c:pt idx="249">
                  <c:v>0.30508</c:v>
                </c:pt>
                <c:pt idx="250">
                  <c:v>0.25908</c:v>
                </c:pt>
                <c:pt idx="251">
                  <c:v>0.13628</c:v>
                </c:pt>
                <c:pt idx="252">
                  <c:v>0.20635</c:v>
                </c:pt>
                <c:pt idx="253">
                  <c:v>0.59091</c:v>
                </c:pt>
                <c:pt idx="254">
                  <c:v>0.27896</c:v>
                </c:pt>
                <c:pt idx="255">
                  <c:v>0.1269</c:v>
                </c:pt>
                <c:pt idx="256">
                  <c:v>0.33009</c:v>
                </c:pt>
                <c:pt idx="257">
                  <c:v>0.21472</c:v>
                </c:pt>
                <c:pt idx="258">
                  <c:v>0.10996</c:v>
                </c:pt>
                <c:pt idx="259">
                  <c:v>0.28297</c:v>
                </c:pt>
                <c:pt idx="260">
                  <c:v>0.05875</c:v>
                </c:pt>
                <c:pt idx="261">
                  <c:v>0.13709</c:v>
                </c:pt>
                <c:pt idx="262">
                  <c:v>0.34921</c:v>
                </c:pt>
                <c:pt idx="263">
                  <c:v>0.27286</c:v>
                </c:pt>
                <c:pt idx="264">
                  <c:v>0.26667</c:v>
                </c:pt>
                <c:pt idx="265">
                  <c:v>0.0219</c:v>
                </c:pt>
                <c:pt idx="266">
                  <c:v>0.24901</c:v>
                </c:pt>
                <c:pt idx="267">
                  <c:v>0.45316</c:v>
                </c:pt>
                <c:pt idx="268">
                  <c:v>0.43716577540107</c:v>
                </c:pt>
                <c:pt idx="269">
                  <c:v>0.37947</c:v>
                </c:pt>
                <c:pt idx="270">
                  <c:v>0.52077</c:v>
                </c:pt>
                <c:pt idx="271">
                  <c:v>0.32542</c:v>
                </c:pt>
                <c:pt idx="272">
                  <c:v>0.125</c:v>
                </c:pt>
                <c:pt idx="273">
                  <c:v>0.35762</c:v>
                </c:pt>
                <c:pt idx="274">
                  <c:v>0.26087</c:v>
                </c:pt>
                <c:pt idx="275">
                  <c:v>0.2437</c:v>
                </c:pt>
                <c:pt idx="276">
                  <c:v>0.30392</c:v>
                </c:pt>
                <c:pt idx="277">
                  <c:v>0.33471</c:v>
                </c:pt>
                <c:pt idx="278">
                  <c:v>0.38619</c:v>
                </c:pt>
                <c:pt idx="279">
                  <c:v>0.32373</c:v>
                </c:pt>
                <c:pt idx="280">
                  <c:v>0.27273</c:v>
                </c:pt>
                <c:pt idx="281">
                  <c:v>0.35047</c:v>
                </c:pt>
                <c:pt idx="282">
                  <c:v>0.33989</c:v>
                </c:pt>
                <c:pt idx="283">
                  <c:v>0.28777</c:v>
                </c:pt>
                <c:pt idx="284">
                  <c:v>0.18956</c:v>
                </c:pt>
                <c:pt idx="285">
                  <c:v>0.29385</c:v>
                </c:pt>
                <c:pt idx="286">
                  <c:v>0.34585</c:v>
                </c:pt>
                <c:pt idx="287">
                  <c:v>0.25073</c:v>
                </c:pt>
                <c:pt idx="288">
                  <c:v>0.14785</c:v>
                </c:pt>
                <c:pt idx="289">
                  <c:v>0.34073</c:v>
                </c:pt>
                <c:pt idx="290">
                  <c:v>0.33653</c:v>
                </c:pt>
                <c:pt idx="291">
                  <c:v>0.38679</c:v>
                </c:pt>
                <c:pt idx="292">
                  <c:v>0.29825</c:v>
                </c:pt>
                <c:pt idx="293">
                  <c:v>0.23211</c:v>
                </c:pt>
                <c:pt idx="294">
                  <c:v>0.44661</c:v>
                </c:pt>
                <c:pt idx="295">
                  <c:v>0.14729</c:v>
                </c:pt>
                <c:pt idx="296">
                  <c:v>0.30028</c:v>
                </c:pt>
                <c:pt idx="297">
                  <c:v>0.15864</c:v>
                </c:pt>
                <c:pt idx="298">
                  <c:v>0.29244</c:v>
                </c:pt>
                <c:pt idx="299">
                  <c:v>0.6635</c:v>
                </c:pt>
                <c:pt idx="300">
                  <c:v>0.43013</c:v>
                </c:pt>
                <c:pt idx="301">
                  <c:v>0.28074</c:v>
                </c:pt>
                <c:pt idx="302">
                  <c:v>0.46006</c:v>
                </c:pt>
                <c:pt idx="303">
                  <c:v>0.1577</c:v>
                </c:pt>
                <c:pt idx="304">
                  <c:v>0.55122</c:v>
                </c:pt>
                <c:pt idx="305">
                  <c:v>0.0</c:v>
                </c:pt>
                <c:pt idx="306">
                  <c:v>0.42102</c:v>
                </c:pt>
                <c:pt idx="307">
                  <c:v>0.39539</c:v>
                </c:pt>
                <c:pt idx="308">
                  <c:v>0.39299</c:v>
                </c:pt>
                <c:pt idx="309">
                  <c:v>0.42621</c:v>
                </c:pt>
                <c:pt idx="310">
                  <c:v>0.31635</c:v>
                </c:pt>
                <c:pt idx="311">
                  <c:v>0.83493</c:v>
                </c:pt>
                <c:pt idx="312">
                  <c:v>0.3631</c:v>
                </c:pt>
                <c:pt idx="313">
                  <c:v>0.20192</c:v>
                </c:pt>
                <c:pt idx="314">
                  <c:v>0.0</c:v>
                </c:pt>
                <c:pt idx="315">
                  <c:v>0.22259</c:v>
                </c:pt>
                <c:pt idx="316">
                  <c:v>0.44112</c:v>
                </c:pt>
                <c:pt idx="317">
                  <c:v>0.72414</c:v>
                </c:pt>
                <c:pt idx="318">
                  <c:v>0.40398</c:v>
                </c:pt>
                <c:pt idx="319">
                  <c:v>0.40975</c:v>
                </c:pt>
                <c:pt idx="320">
                  <c:v>0.36571</c:v>
                </c:pt>
                <c:pt idx="321">
                  <c:v>0.47649</c:v>
                </c:pt>
                <c:pt idx="322">
                  <c:v>0.87319</c:v>
                </c:pt>
                <c:pt idx="323">
                  <c:v>0.35583</c:v>
                </c:pt>
                <c:pt idx="324">
                  <c:v>0.0</c:v>
                </c:pt>
                <c:pt idx="325">
                  <c:v>0.14532</c:v>
                </c:pt>
                <c:pt idx="326">
                  <c:v>0.16129</c:v>
                </c:pt>
                <c:pt idx="327">
                  <c:v>0.33529</c:v>
                </c:pt>
                <c:pt idx="328">
                  <c:v>0.23504</c:v>
                </c:pt>
                <c:pt idx="329">
                  <c:v>0.00147</c:v>
                </c:pt>
                <c:pt idx="330">
                  <c:v>0.25225</c:v>
                </c:pt>
                <c:pt idx="331">
                  <c:v>0.24123</c:v>
                </c:pt>
                <c:pt idx="332">
                  <c:v>0.22222</c:v>
                </c:pt>
                <c:pt idx="333">
                  <c:v>0.12609</c:v>
                </c:pt>
                <c:pt idx="334">
                  <c:v>0.22357</c:v>
                </c:pt>
                <c:pt idx="335">
                  <c:v>0.41331</c:v>
                </c:pt>
                <c:pt idx="336">
                  <c:v>0.00387</c:v>
                </c:pt>
                <c:pt idx="337">
                  <c:v>0.30457</c:v>
                </c:pt>
                <c:pt idx="338">
                  <c:v>0.36861</c:v>
                </c:pt>
                <c:pt idx="339">
                  <c:v>0.46436</c:v>
                </c:pt>
                <c:pt idx="340">
                  <c:v>0.17311</c:v>
                </c:pt>
                <c:pt idx="341">
                  <c:v>0.22622</c:v>
                </c:pt>
                <c:pt idx="342">
                  <c:v>0.36691</c:v>
                </c:pt>
                <c:pt idx="343">
                  <c:v>0.15334</c:v>
                </c:pt>
                <c:pt idx="344">
                  <c:v>0.25591</c:v>
                </c:pt>
                <c:pt idx="345">
                  <c:v>0.14439</c:v>
                </c:pt>
                <c:pt idx="346">
                  <c:v>0.41579</c:v>
                </c:pt>
                <c:pt idx="347">
                  <c:v>0.47425</c:v>
                </c:pt>
                <c:pt idx="348">
                  <c:v>0.37716</c:v>
                </c:pt>
                <c:pt idx="349">
                  <c:v>0.43177</c:v>
                </c:pt>
                <c:pt idx="350">
                  <c:v>0.41364</c:v>
                </c:pt>
                <c:pt idx="351">
                  <c:v>0.32361</c:v>
                </c:pt>
                <c:pt idx="352">
                  <c:v>0.3425</c:v>
                </c:pt>
                <c:pt idx="353">
                  <c:v>0.40405</c:v>
                </c:pt>
                <c:pt idx="354">
                  <c:v>0.27778</c:v>
                </c:pt>
                <c:pt idx="355">
                  <c:v>0.42857</c:v>
                </c:pt>
                <c:pt idx="356">
                  <c:v>0.62195</c:v>
                </c:pt>
                <c:pt idx="357">
                  <c:v>0.39359</c:v>
                </c:pt>
                <c:pt idx="358">
                  <c:v>0.19551</c:v>
                </c:pt>
                <c:pt idx="359">
                  <c:v>0.39931</c:v>
                </c:pt>
                <c:pt idx="360">
                  <c:v>0.41321</c:v>
                </c:pt>
                <c:pt idx="361">
                  <c:v>0.63709</c:v>
                </c:pt>
                <c:pt idx="362">
                  <c:v>0.34936</c:v>
                </c:pt>
                <c:pt idx="363">
                  <c:v>0.31907</c:v>
                </c:pt>
                <c:pt idx="364">
                  <c:v>0.83945</c:v>
                </c:pt>
                <c:pt idx="365">
                  <c:v>0.46</c:v>
                </c:pt>
                <c:pt idx="366">
                  <c:v>0.52975</c:v>
                </c:pt>
                <c:pt idx="367">
                  <c:v>0.5625</c:v>
                </c:pt>
                <c:pt idx="368">
                  <c:v>0.33485</c:v>
                </c:pt>
                <c:pt idx="369">
                  <c:v>0.14094</c:v>
                </c:pt>
                <c:pt idx="370">
                  <c:v>0.32646</c:v>
                </c:pt>
                <c:pt idx="371">
                  <c:v>0.34956</c:v>
                </c:pt>
                <c:pt idx="372">
                  <c:v>0.47739</c:v>
                </c:pt>
                <c:pt idx="373">
                  <c:v>0.34633</c:v>
                </c:pt>
                <c:pt idx="374">
                  <c:v>0.10084</c:v>
                </c:pt>
                <c:pt idx="375">
                  <c:v>0.44737</c:v>
                </c:pt>
                <c:pt idx="376">
                  <c:v>0.40892</c:v>
                </c:pt>
                <c:pt idx="377">
                  <c:v>0.44098</c:v>
                </c:pt>
                <c:pt idx="378">
                  <c:v>0.57179</c:v>
                </c:pt>
                <c:pt idx="379">
                  <c:v>0.38402</c:v>
                </c:pt>
                <c:pt idx="380">
                  <c:v>0.50563</c:v>
                </c:pt>
                <c:pt idx="381">
                  <c:v>0.57466</c:v>
                </c:pt>
                <c:pt idx="382">
                  <c:v>0.6145</c:v>
                </c:pt>
                <c:pt idx="383">
                  <c:v>0.28632</c:v>
                </c:pt>
                <c:pt idx="384">
                  <c:v>0.56707</c:v>
                </c:pt>
                <c:pt idx="385">
                  <c:v>0.33579</c:v>
                </c:pt>
                <c:pt idx="386">
                  <c:v>0.53483</c:v>
                </c:pt>
                <c:pt idx="387">
                  <c:v>0.15433</c:v>
                </c:pt>
                <c:pt idx="388">
                  <c:v>0.4523</c:v>
                </c:pt>
                <c:pt idx="389">
                  <c:v>0.27806</c:v>
                </c:pt>
                <c:pt idx="390">
                  <c:v>0.61327</c:v>
                </c:pt>
                <c:pt idx="391">
                  <c:v>0.17976</c:v>
                </c:pt>
                <c:pt idx="392">
                  <c:v>0.31165</c:v>
                </c:pt>
                <c:pt idx="393">
                  <c:v>0.46009</c:v>
                </c:pt>
                <c:pt idx="394">
                  <c:v>0.0</c:v>
                </c:pt>
                <c:pt idx="395">
                  <c:v>0.49438</c:v>
                </c:pt>
                <c:pt idx="396">
                  <c:v>0.61958</c:v>
                </c:pt>
                <c:pt idx="397">
                  <c:v>0.40441</c:v>
                </c:pt>
                <c:pt idx="398">
                  <c:v>0.237037037037037</c:v>
                </c:pt>
                <c:pt idx="399">
                  <c:v>0.67582</c:v>
                </c:pt>
                <c:pt idx="400">
                  <c:v>0.32013</c:v>
                </c:pt>
                <c:pt idx="401">
                  <c:v>0.51228</c:v>
                </c:pt>
                <c:pt idx="402">
                  <c:v>0.64068</c:v>
                </c:pt>
                <c:pt idx="403">
                  <c:v>0.34848</c:v>
                </c:pt>
                <c:pt idx="404">
                  <c:v>0.30058</c:v>
                </c:pt>
                <c:pt idx="405">
                  <c:v>0.33206</c:v>
                </c:pt>
                <c:pt idx="406">
                  <c:v>0.70898</c:v>
                </c:pt>
                <c:pt idx="407">
                  <c:v>0.30149</c:v>
                </c:pt>
                <c:pt idx="408">
                  <c:v>0.84289</c:v>
                </c:pt>
                <c:pt idx="409">
                  <c:v>0.31458</c:v>
                </c:pt>
                <c:pt idx="410">
                  <c:v>0.3066</c:v>
                </c:pt>
                <c:pt idx="411">
                  <c:v>0.3365</c:v>
                </c:pt>
                <c:pt idx="412">
                  <c:v>0.12</c:v>
                </c:pt>
                <c:pt idx="413">
                  <c:v>0.47548</c:v>
                </c:pt>
                <c:pt idx="414">
                  <c:v>0.47781</c:v>
                </c:pt>
                <c:pt idx="415">
                  <c:v>0.45135</c:v>
                </c:pt>
                <c:pt idx="416">
                  <c:v>0.32466</c:v>
                </c:pt>
                <c:pt idx="417">
                  <c:v>0.64256</c:v>
                </c:pt>
                <c:pt idx="418">
                  <c:v>0.56116</c:v>
                </c:pt>
                <c:pt idx="419">
                  <c:v>0.74107</c:v>
                </c:pt>
                <c:pt idx="420">
                  <c:v>0.30921</c:v>
                </c:pt>
                <c:pt idx="421">
                  <c:v>0.2686</c:v>
                </c:pt>
                <c:pt idx="422">
                  <c:v>0.20426</c:v>
                </c:pt>
                <c:pt idx="423">
                  <c:v>0.62887</c:v>
                </c:pt>
                <c:pt idx="424">
                  <c:v>0.20267</c:v>
                </c:pt>
                <c:pt idx="425">
                  <c:v>0.40031</c:v>
                </c:pt>
                <c:pt idx="426">
                  <c:v>0.52959</c:v>
                </c:pt>
                <c:pt idx="427">
                  <c:v>0.6375</c:v>
                </c:pt>
                <c:pt idx="428">
                  <c:v>0.64677</c:v>
                </c:pt>
                <c:pt idx="429">
                  <c:v>0.39327</c:v>
                </c:pt>
                <c:pt idx="430">
                  <c:v>0.41297</c:v>
                </c:pt>
                <c:pt idx="431">
                  <c:v>0.44208</c:v>
                </c:pt>
                <c:pt idx="432">
                  <c:v>0.81605</c:v>
                </c:pt>
                <c:pt idx="433">
                  <c:v>0.9181</c:v>
                </c:pt>
              </c:numCache>
            </c:numRef>
          </c:xVal>
          <c:yVal>
            <c:numRef>
              <c:f>Sheet1!$D$2:$D$435</c:f>
              <c:numCache>
                <c:formatCode>General</c:formatCode>
                <c:ptCount val="43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0072</c:v>
                </c:pt>
                <c:pt idx="33">
                  <c:v>0.00103</c:v>
                </c:pt>
                <c:pt idx="34">
                  <c:v>0.00125</c:v>
                </c:pt>
                <c:pt idx="35">
                  <c:v>0.0014</c:v>
                </c:pt>
                <c:pt idx="36">
                  <c:v>0.00147</c:v>
                </c:pt>
                <c:pt idx="37">
                  <c:v>0.0017</c:v>
                </c:pt>
                <c:pt idx="38">
                  <c:v>0.00188</c:v>
                </c:pt>
                <c:pt idx="39">
                  <c:v>0.00262</c:v>
                </c:pt>
                <c:pt idx="40">
                  <c:v>0.00274</c:v>
                </c:pt>
                <c:pt idx="41">
                  <c:v>0.00277</c:v>
                </c:pt>
                <c:pt idx="42">
                  <c:v>0.00287</c:v>
                </c:pt>
                <c:pt idx="43">
                  <c:v>0.00402</c:v>
                </c:pt>
                <c:pt idx="44">
                  <c:v>0.00451</c:v>
                </c:pt>
                <c:pt idx="45">
                  <c:v>0.00556</c:v>
                </c:pt>
                <c:pt idx="46">
                  <c:v>0.00731</c:v>
                </c:pt>
                <c:pt idx="47">
                  <c:v>0.02055</c:v>
                </c:pt>
                <c:pt idx="48">
                  <c:v>0.03595</c:v>
                </c:pt>
                <c:pt idx="49">
                  <c:v>0.0366</c:v>
                </c:pt>
                <c:pt idx="50">
                  <c:v>0.04555</c:v>
                </c:pt>
                <c:pt idx="51">
                  <c:v>0.0458</c:v>
                </c:pt>
                <c:pt idx="52">
                  <c:v>0.04847</c:v>
                </c:pt>
                <c:pt idx="53">
                  <c:v>0.0495</c:v>
                </c:pt>
                <c:pt idx="54">
                  <c:v>0.0515</c:v>
                </c:pt>
                <c:pt idx="55">
                  <c:v>0.05376</c:v>
                </c:pt>
                <c:pt idx="56">
                  <c:v>0.05443</c:v>
                </c:pt>
                <c:pt idx="57">
                  <c:v>0.05498</c:v>
                </c:pt>
                <c:pt idx="58">
                  <c:v>0.0557</c:v>
                </c:pt>
                <c:pt idx="59">
                  <c:v>0.05652</c:v>
                </c:pt>
                <c:pt idx="60">
                  <c:v>0.05699</c:v>
                </c:pt>
                <c:pt idx="61">
                  <c:v>0.05992</c:v>
                </c:pt>
                <c:pt idx="62">
                  <c:v>0.06154</c:v>
                </c:pt>
                <c:pt idx="63">
                  <c:v>0.06271</c:v>
                </c:pt>
                <c:pt idx="64">
                  <c:v>0.06393</c:v>
                </c:pt>
                <c:pt idx="65">
                  <c:v>0.06442</c:v>
                </c:pt>
                <c:pt idx="66">
                  <c:v>0.06522</c:v>
                </c:pt>
                <c:pt idx="67">
                  <c:v>0.06731</c:v>
                </c:pt>
                <c:pt idx="68">
                  <c:v>0.06882</c:v>
                </c:pt>
                <c:pt idx="69">
                  <c:v>0.07249</c:v>
                </c:pt>
                <c:pt idx="70">
                  <c:v>0.07282</c:v>
                </c:pt>
                <c:pt idx="71">
                  <c:v>0.07888</c:v>
                </c:pt>
                <c:pt idx="72">
                  <c:v>0.08173</c:v>
                </c:pt>
                <c:pt idx="73">
                  <c:v>0.08483</c:v>
                </c:pt>
                <c:pt idx="74">
                  <c:v>0.08644</c:v>
                </c:pt>
                <c:pt idx="75">
                  <c:v>0.08861</c:v>
                </c:pt>
                <c:pt idx="76">
                  <c:v>0.08868</c:v>
                </c:pt>
                <c:pt idx="77">
                  <c:v>0.09016</c:v>
                </c:pt>
                <c:pt idx="78">
                  <c:v>0.09031</c:v>
                </c:pt>
                <c:pt idx="79">
                  <c:v>0.09091</c:v>
                </c:pt>
                <c:pt idx="80">
                  <c:v>0.09164</c:v>
                </c:pt>
                <c:pt idx="81">
                  <c:v>0.09228</c:v>
                </c:pt>
                <c:pt idx="82">
                  <c:v>0.09467</c:v>
                </c:pt>
                <c:pt idx="83">
                  <c:v>0.09496</c:v>
                </c:pt>
                <c:pt idx="84">
                  <c:v>0.09617</c:v>
                </c:pt>
                <c:pt idx="85">
                  <c:v>0.09656</c:v>
                </c:pt>
                <c:pt idx="86">
                  <c:v>0.09754</c:v>
                </c:pt>
                <c:pt idx="87">
                  <c:v>0.10244</c:v>
                </c:pt>
                <c:pt idx="88">
                  <c:v>0.10325</c:v>
                </c:pt>
                <c:pt idx="89">
                  <c:v>0.10335</c:v>
                </c:pt>
                <c:pt idx="90">
                  <c:v>0.10383</c:v>
                </c:pt>
                <c:pt idx="91">
                  <c:v>0.10788</c:v>
                </c:pt>
                <c:pt idx="92">
                  <c:v>0.10811</c:v>
                </c:pt>
                <c:pt idx="93">
                  <c:v>0.10887</c:v>
                </c:pt>
                <c:pt idx="94">
                  <c:v>0.11256</c:v>
                </c:pt>
                <c:pt idx="95">
                  <c:v>0.11619</c:v>
                </c:pt>
                <c:pt idx="96">
                  <c:v>0.117</c:v>
                </c:pt>
                <c:pt idx="97">
                  <c:v>0.11725</c:v>
                </c:pt>
                <c:pt idx="98">
                  <c:v>0.11735</c:v>
                </c:pt>
                <c:pt idx="99">
                  <c:v>0.12121</c:v>
                </c:pt>
                <c:pt idx="100">
                  <c:v>0.12321</c:v>
                </c:pt>
                <c:pt idx="101">
                  <c:v>0.12403</c:v>
                </c:pt>
                <c:pt idx="102">
                  <c:v>0.1246</c:v>
                </c:pt>
                <c:pt idx="103">
                  <c:v>0.1281</c:v>
                </c:pt>
                <c:pt idx="104">
                  <c:v>0.12861</c:v>
                </c:pt>
                <c:pt idx="105">
                  <c:v>0.12927</c:v>
                </c:pt>
                <c:pt idx="106">
                  <c:v>0.12935</c:v>
                </c:pt>
                <c:pt idx="107">
                  <c:v>0.12991</c:v>
                </c:pt>
                <c:pt idx="108">
                  <c:v>0.13129</c:v>
                </c:pt>
                <c:pt idx="109">
                  <c:v>0.13237</c:v>
                </c:pt>
                <c:pt idx="110">
                  <c:v>0.1336</c:v>
                </c:pt>
                <c:pt idx="111">
                  <c:v>0.13408</c:v>
                </c:pt>
                <c:pt idx="112">
                  <c:v>0.13552</c:v>
                </c:pt>
                <c:pt idx="113">
                  <c:v>0.13682</c:v>
                </c:pt>
                <c:pt idx="114">
                  <c:v>0.13939</c:v>
                </c:pt>
                <c:pt idx="115">
                  <c:v>0.14038</c:v>
                </c:pt>
                <c:pt idx="116">
                  <c:v>0.14062</c:v>
                </c:pt>
                <c:pt idx="117">
                  <c:v>0.14267</c:v>
                </c:pt>
                <c:pt idx="118">
                  <c:v>0.14286</c:v>
                </c:pt>
                <c:pt idx="119">
                  <c:v>0.14331</c:v>
                </c:pt>
                <c:pt idx="120">
                  <c:v>0.14408</c:v>
                </c:pt>
                <c:pt idx="121">
                  <c:v>0.14599</c:v>
                </c:pt>
                <c:pt idx="122">
                  <c:v>0.14653</c:v>
                </c:pt>
                <c:pt idx="123">
                  <c:v>0.14841</c:v>
                </c:pt>
                <c:pt idx="124">
                  <c:v>0.14847</c:v>
                </c:pt>
                <c:pt idx="125">
                  <c:v>0.15198</c:v>
                </c:pt>
                <c:pt idx="126">
                  <c:v>0.15244</c:v>
                </c:pt>
                <c:pt idx="127">
                  <c:v>0.15328</c:v>
                </c:pt>
                <c:pt idx="128">
                  <c:v>0.15432</c:v>
                </c:pt>
                <c:pt idx="129">
                  <c:v>0.15975</c:v>
                </c:pt>
                <c:pt idx="130">
                  <c:v>0.16049</c:v>
                </c:pt>
                <c:pt idx="131">
                  <c:v>0.16052</c:v>
                </c:pt>
                <c:pt idx="132">
                  <c:v>0.16159</c:v>
                </c:pt>
                <c:pt idx="133">
                  <c:v>0.16169</c:v>
                </c:pt>
                <c:pt idx="134">
                  <c:v>0.16242</c:v>
                </c:pt>
                <c:pt idx="135">
                  <c:v>0.16361</c:v>
                </c:pt>
                <c:pt idx="136">
                  <c:v>0.16507</c:v>
                </c:pt>
                <c:pt idx="137">
                  <c:v>0.16523</c:v>
                </c:pt>
                <c:pt idx="138">
                  <c:v>0.16623</c:v>
                </c:pt>
                <c:pt idx="139">
                  <c:v>0.17226</c:v>
                </c:pt>
                <c:pt idx="140">
                  <c:v>0.17361</c:v>
                </c:pt>
                <c:pt idx="141">
                  <c:v>0.17391</c:v>
                </c:pt>
                <c:pt idx="142">
                  <c:v>0.17559</c:v>
                </c:pt>
                <c:pt idx="143">
                  <c:v>0.17586</c:v>
                </c:pt>
                <c:pt idx="144">
                  <c:v>0.1759</c:v>
                </c:pt>
                <c:pt idx="145">
                  <c:v>0.17797</c:v>
                </c:pt>
                <c:pt idx="146">
                  <c:v>0.17804</c:v>
                </c:pt>
                <c:pt idx="147">
                  <c:v>0.17904</c:v>
                </c:pt>
                <c:pt idx="148">
                  <c:v>0.18027</c:v>
                </c:pt>
                <c:pt idx="149">
                  <c:v>0.18041</c:v>
                </c:pt>
                <c:pt idx="150">
                  <c:v>0.18063</c:v>
                </c:pt>
                <c:pt idx="151">
                  <c:v>0.18182</c:v>
                </c:pt>
                <c:pt idx="152">
                  <c:v>0.18182</c:v>
                </c:pt>
                <c:pt idx="153">
                  <c:v>0.18411</c:v>
                </c:pt>
                <c:pt idx="154">
                  <c:v>0.18436</c:v>
                </c:pt>
                <c:pt idx="155">
                  <c:v>0.18458</c:v>
                </c:pt>
                <c:pt idx="156">
                  <c:v>0.18552</c:v>
                </c:pt>
                <c:pt idx="157">
                  <c:v>0.1866</c:v>
                </c:pt>
                <c:pt idx="158">
                  <c:v>0.187</c:v>
                </c:pt>
                <c:pt idx="159">
                  <c:v>0.18739</c:v>
                </c:pt>
                <c:pt idx="160">
                  <c:v>0.18803</c:v>
                </c:pt>
                <c:pt idx="161">
                  <c:v>0.18826</c:v>
                </c:pt>
                <c:pt idx="162">
                  <c:v>0.18896</c:v>
                </c:pt>
                <c:pt idx="163">
                  <c:v>0.18913</c:v>
                </c:pt>
                <c:pt idx="164">
                  <c:v>0.18949</c:v>
                </c:pt>
                <c:pt idx="165">
                  <c:v>0.18993</c:v>
                </c:pt>
                <c:pt idx="166">
                  <c:v>0.19048</c:v>
                </c:pt>
                <c:pt idx="167">
                  <c:v>0.19086</c:v>
                </c:pt>
                <c:pt idx="168">
                  <c:v>0.19302</c:v>
                </c:pt>
                <c:pt idx="169">
                  <c:v>0.1944</c:v>
                </c:pt>
                <c:pt idx="170">
                  <c:v>0.19448</c:v>
                </c:pt>
                <c:pt idx="171">
                  <c:v>0.19512</c:v>
                </c:pt>
                <c:pt idx="172">
                  <c:v>0.19562</c:v>
                </c:pt>
                <c:pt idx="173">
                  <c:v>0.19623</c:v>
                </c:pt>
                <c:pt idx="174">
                  <c:v>0.19634</c:v>
                </c:pt>
                <c:pt idx="175">
                  <c:v>0.19697</c:v>
                </c:pt>
                <c:pt idx="176">
                  <c:v>0.19856</c:v>
                </c:pt>
                <c:pt idx="177">
                  <c:v>0.2</c:v>
                </c:pt>
                <c:pt idx="178">
                  <c:v>0.20064</c:v>
                </c:pt>
                <c:pt idx="179">
                  <c:v>0.20137</c:v>
                </c:pt>
                <c:pt idx="180">
                  <c:v>0.20225</c:v>
                </c:pt>
                <c:pt idx="181">
                  <c:v>0.20359</c:v>
                </c:pt>
                <c:pt idx="182">
                  <c:v>0.2038</c:v>
                </c:pt>
                <c:pt idx="183">
                  <c:v>0.20488</c:v>
                </c:pt>
                <c:pt idx="184">
                  <c:v>0.20519</c:v>
                </c:pt>
                <c:pt idx="185">
                  <c:v>0.20708</c:v>
                </c:pt>
                <c:pt idx="186">
                  <c:v>0.20833</c:v>
                </c:pt>
                <c:pt idx="187">
                  <c:v>0.2102</c:v>
                </c:pt>
                <c:pt idx="188">
                  <c:v>0.21068</c:v>
                </c:pt>
                <c:pt idx="189">
                  <c:v>0.21212</c:v>
                </c:pt>
                <c:pt idx="190">
                  <c:v>0.21301</c:v>
                </c:pt>
                <c:pt idx="191">
                  <c:v>0.21562</c:v>
                </c:pt>
                <c:pt idx="192">
                  <c:v>0.21764</c:v>
                </c:pt>
                <c:pt idx="193">
                  <c:v>0.21771</c:v>
                </c:pt>
                <c:pt idx="194">
                  <c:v>0.21794</c:v>
                </c:pt>
                <c:pt idx="195">
                  <c:v>0.21884</c:v>
                </c:pt>
                <c:pt idx="196">
                  <c:v>0.21887</c:v>
                </c:pt>
                <c:pt idx="197">
                  <c:v>0.22209</c:v>
                </c:pt>
                <c:pt idx="198">
                  <c:v>0.22308</c:v>
                </c:pt>
                <c:pt idx="199">
                  <c:v>0.22449</c:v>
                </c:pt>
                <c:pt idx="200">
                  <c:v>0.22449</c:v>
                </c:pt>
                <c:pt idx="201">
                  <c:v>0.225</c:v>
                </c:pt>
                <c:pt idx="202">
                  <c:v>0.22535</c:v>
                </c:pt>
                <c:pt idx="203">
                  <c:v>0.225769669327252</c:v>
                </c:pt>
                <c:pt idx="204">
                  <c:v>0.22592</c:v>
                </c:pt>
                <c:pt idx="205">
                  <c:v>0.22642</c:v>
                </c:pt>
                <c:pt idx="206">
                  <c:v>0.22669</c:v>
                </c:pt>
                <c:pt idx="207">
                  <c:v>0.22694</c:v>
                </c:pt>
                <c:pt idx="208">
                  <c:v>0.23144</c:v>
                </c:pt>
                <c:pt idx="209">
                  <c:v>0.23223</c:v>
                </c:pt>
                <c:pt idx="210">
                  <c:v>0.2335</c:v>
                </c:pt>
                <c:pt idx="211">
                  <c:v>0.2348</c:v>
                </c:pt>
                <c:pt idx="212">
                  <c:v>0.23688</c:v>
                </c:pt>
                <c:pt idx="213">
                  <c:v>0.2373</c:v>
                </c:pt>
                <c:pt idx="214">
                  <c:v>0.23734</c:v>
                </c:pt>
                <c:pt idx="215">
                  <c:v>0.2398</c:v>
                </c:pt>
                <c:pt idx="216">
                  <c:v>0.23982</c:v>
                </c:pt>
                <c:pt idx="217">
                  <c:v>0.24</c:v>
                </c:pt>
                <c:pt idx="218">
                  <c:v>0.24152</c:v>
                </c:pt>
                <c:pt idx="219">
                  <c:v>0.24297</c:v>
                </c:pt>
                <c:pt idx="220">
                  <c:v>0.24302</c:v>
                </c:pt>
                <c:pt idx="221">
                  <c:v>0.24312</c:v>
                </c:pt>
                <c:pt idx="222">
                  <c:v>0.24514</c:v>
                </c:pt>
                <c:pt idx="223">
                  <c:v>0.24542</c:v>
                </c:pt>
                <c:pt idx="224">
                  <c:v>0.24583</c:v>
                </c:pt>
                <c:pt idx="225">
                  <c:v>0.24612</c:v>
                </c:pt>
                <c:pt idx="226">
                  <c:v>0.24642</c:v>
                </c:pt>
                <c:pt idx="227">
                  <c:v>0.24736</c:v>
                </c:pt>
                <c:pt idx="228">
                  <c:v>0.24837</c:v>
                </c:pt>
                <c:pt idx="229">
                  <c:v>0.24961</c:v>
                </c:pt>
                <c:pt idx="230">
                  <c:v>0.25243</c:v>
                </c:pt>
                <c:pt idx="231">
                  <c:v>0.25393</c:v>
                </c:pt>
                <c:pt idx="232">
                  <c:v>0.25397</c:v>
                </c:pt>
                <c:pt idx="233">
                  <c:v>0.25427</c:v>
                </c:pt>
                <c:pt idx="234">
                  <c:v>0.25694</c:v>
                </c:pt>
                <c:pt idx="235">
                  <c:v>0.26049</c:v>
                </c:pt>
                <c:pt idx="236">
                  <c:v>0.26068</c:v>
                </c:pt>
                <c:pt idx="237">
                  <c:v>0.26075</c:v>
                </c:pt>
                <c:pt idx="238">
                  <c:v>0.26102</c:v>
                </c:pt>
                <c:pt idx="239">
                  <c:v>0.26431</c:v>
                </c:pt>
                <c:pt idx="240">
                  <c:v>0.26437</c:v>
                </c:pt>
                <c:pt idx="241">
                  <c:v>0.26715</c:v>
                </c:pt>
                <c:pt idx="242">
                  <c:v>0.26767</c:v>
                </c:pt>
                <c:pt idx="243">
                  <c:v>0.26775</c:v>
                </c:pt>
                <c:pt idx="244">
                  <c:v>0.2681</c:v>
                </c:pt>
                <c:pt idx="245">
                  <c:v>0.27195</c:v>
                </c:pt>
                <c:pt idx="246">
                  <c:v>0.27425</c:v>
                </c:pt>
                <c:pt idx="247">
                  <c:v>0.27559</c:v>
                </c:pt>
                <c:pt idx="248">
                  <c:v>0.2757</c:v>
                </c:pt>
                <c:pt idx="249">
                  <c:v>0.27633</c:v>
                </c:pt>
                <c:pt idx="250">
                  <c:v>0.2779</c:v>
                </c:pt>
                <c:pt idx="251">
                  <c:v>0.27981</c:v>
                </c:pt>
                <c:pt idx="252">
                  <c:v>0.28045</c:v>
                </c:pt>
                <c:pt idx="253">
                  <c:v>0.28436</c:v>
                </c:pt>
                <c:pt idx="254">
                  <c:v>0.28539</c:v>
                </c:pt>
                <c:pt idx="255">
                  <c:v>0.28571</c:v>
                </c:pt>
                <c:pt idx="256">
                  <c:v>0.28683</c:v>
                </c:pt>
                <c:pt idx="257">
                  <c:v>0.28707</c:v>
                </c:pt>
                <c:pt idx="258">
                  <c:v>0.28808</c:v>
                </c:pt>
                <c:pt idx="259">
                  <c:v>0.29014</c:v>
                </c:pt>
                <c:pt idx="260">
                  <c:v>0.29093</c:v>
                </c:pt>
                <c:pt idx="261">
                  <c:v>0.29217</c:v>
                </c:pt>
                <c:pt idx="262">
                  <c:v>0.29228</c:v>
                </c:pt>
                <c:pt idx="263">
                  <c:v>0.29229</c:v>
                </c:pt>
                <c:pt idx="264">
                  <c:v>0.29348</c:v>
                </c:pt>
                <c:pt idx="265">
                  <c:v>0.29412</c:v>
                </c:pt>
                <c:pt idx="266">
                  <c:v>0.29412</c:v>
                </c:pt>
                <c:pt idx="267">
                  <c:v>0.29454</c:v>
                </c:pt>
                <c:pt idx="268">
                  <c:v>0.297619047619048</c:v>
                </c:pt>
                <c:pt idx="269">
                  <c:v>0.29907</c:v>
                </c:pt>
                <c:pt idx="270">
                  <c:v>0.30352</c:v>
                </c:pt>
                <c:pt idx="271">
                  <c:v>0.30409</c:v>
                </c:pt>
                <c:pt idx="272">
                  <c:v>0.30423</c:v>
                </c:pt>
                <c:pt idx="273">
                  <c:v>0.30481</c:v>
                </c:pt>
                <c:pt idx="274">
                  <c:v>0.30488</c:v>
                </c:pt>
                <c:pt idx="275">
                  <c:v>0.3085</c:v>
                </c:pt>
                <c:pt idx="276">
                  <c:v>0.31014</c:v>
                </c:pt>
                <c:pt idx="277">
                  <c:v>0.31291</c:v>
                </c:pt>
                <c:pt idx="278">
                  <c:v>0.31314</c:v>
                </c:pt>
                <c:pt idx="279">
                  <c:v>0.31389</c:v>
                </c:pt>
                <c:pt idx="280">
                  <c:v>0.31915</c:v>
                </c:pt>
                <c:pt idx="281">
                  <c:v>0.32222</c:v>
                </c:pt>
                <c:pt idx="282">
                  <c:v>0.32317</c:v>
                </c:pt>
                <c:pt idx="283">
                  <c:v>0.3232</c:v>
                </c:pt>
                <c:pt idx="284">
                  <c:v>0.3275</c:v>
                </c:pt>
                <c:pt idx="285">
                  <c:v>0.3279</c:v>
                </c:pt>
                <c:pt idx="286">
                  <c:v>0.3284</c:v>
                </c:pt>
                <c:pt idx="287">
                  <c:v>0.33155</c:v>
                </c:pt>
                <c:pt idx="288">
                  <c:v>0.33483</c:v>
                </c:pt>
                <c:pt idx="289">
                  <c:v>0.33526</c:v>
                </c:pt>
                <c:pt idx="290">
                  <c:v>0.33537</c:v>
                </c:pt>
                <c:pt idx="291">
                  <c:v>0.33626</c:v>
                </c:pt>
                <c:pt idx="292">
                  <c:v>0.33698</c:v>
                </c:pt>
                <c:pt idx="293">
                  <c:v>0.33714</c:v>
                </c:pt>
                <c:pt idx="294">
                  <c:v>0.33977</c:v>
                </c:pt>
                <c:pt idx="295">
                  <c:v>0.33987</c:v>
                </c:pt>
                <c:pt idx="296">
                  <c:v>0.34017</c:v>
                </c:pt>
                <c:pt idx="297">
                  <c:v>0.34209</c:v>
                </c:pt>
                <c:pt idx="298">
                  <c:v>0.34421</c:v>
                </c:pt>
                <c:pt idx="299">
                  <c:v>0.34532</c:v>
                </c:pt>
                <c:pt idx="300">
                  <c:v>0.34544</c:v>
                </c:pt>
                <c:pt idx="301">
                  <c:v>0.34711</c:v>
                </c:pt>
                <c:pt idx="302">
                  <c:v>0.34756</c:v>
                </c:pt>
                <c:pt idx="303">
                  <c:v>0.34796</c:v>
                </c:pt>
                <c:pt idx="304">
                  <c:v>0.34844</c:v>
                </c:pt>
                <c:pt idx="305">
                  <c:v>0.34945</c:v>
                </c:pt>
                <c:pt idx="306">
                  <c:v>0.35003</c:v>
                </c:pt>
                <c:pt idx="307">
                  <c:v>0.35117</c:v>
                </c:pt>
                <c:pt idx="308">
                  <c:v>0.35388</c:v>
                </c:pt>
                <c:pt idx="309">
                  <c:v>0.35995</c:v>
                </c:pt>
                <c:pt idx="310">
                  <c:v>0.36096</c:v>
                </c:pt>
                <c:pt idx="311">
                  <c:v>0.36134</c:v>
                </c:pt>
                <c:pt idx="312">
                  <c:v>0.36187</c:v>
                </c:pt>
                <c:pt idx="313">
                  <c:v>0.36275</c:v>
                </c:pt>
                <c:pt idx="314">
                  <c:v>0.36289</c:v>
                </c:pt>
                <c:pt idx="315">
                  <c:v>0.36364</c:v>
                </c:pt>
                <c:pt idx="316">
                  <c:v>0.36467</c:v>
                </c:pt>
                <c:pt idx="317">
                  <c:v>0.36472</c:v>
                </c:pt>
                <c:pt idx="318">
                  <c:v>0.36516</c:v>
                </c:pt>
                <c:pt idx="319">
                  <c:v>0.36686</c:v>
                </c:pt>
                <c:pt idx="320">
                  <c:v>0.36742</c:v>
                </c:pt>
                <c:pt idx="321">
                  <c:v>0.37073</c:v>
                </c:pt>
                <c:pt idx="322">
                  <c:v>0.37118</c:v>
                </c:pt>
                <c:pt idx="323">
                  <c:v>0.37187</c:v>
                </c:pt>
                <c:pt idx="324">
                  <c:v>0.37193</c:v>
                </c:pt>
                <c:pt idx="325">
                  <c:v>0.37209</c:v>
                </c:pt>
                <c:pt idx="326">
                  <c:v>0.37438</c:v>
                </c:pt>
                <c:pt idx="327">
                  <c:v>0.37604</c:v>
                </c:pt>
                <c:pt idx="328">
                  <c:v>0.37634</c:v>
                </c:pt>
                <c:pt idx="329">
                  <c:v>0.37965</c:v>
                </c:pt>
                <c:pt idx="330">
                  <c:v>0.38025</c:v>
                </c:pt>
                <c:pt idx="331">
                  <c:v>0.38079</c:v>
                </c:pt>
                <c:pt idx="332">
                  <c:v>0.38626</c:v>
                </c:pt>
                <c:pt idx="333">
                  <c:v>0.3865</c:v>
                </c:pt>
                <c:pt idx="334">
                  <c:v>0.38746</c:v>
                </c:pt>
                <c:pt idx="335">
                  <c:v>0.38909</c:v>
                </c:pt>
                <c:pt idx="336">
                  <c:v>0.39227</c:v>
                </c:pt>
                <c:pt idx="337">
                  <c:v>0.39726</c:v>
                </c:pt>
                <c:pt idx="338">
                  <c:v>0.4</c:v>
                </c:pt>
                <c:pt idx="339">
                  <c:v>0.40164</c:v>
                </c:pt>
                <c:pt idx="340">
                  <c:v>0.40367</c:v>
                </c:pt>
                <c:pt idx="341">
                  <c:v>0.40456</c:v>
                </c:pt>
                <c:pt idx="342">
                  <c:v>0.40521</c:v>
                </c:pt>
                <c:pt idx="343">
                  <c:v>0.40741</c:v>
                </c:pt>
                <c:pt idx="344">
                  <c:v>0.40758</c:v>
                </c:pt>
                <c:pt idx="345">
                  <c:v>0.40842</c:v>
                </c:pt>
                <c:pt idx="346">
                  <c:v>0.40967</c:v>
                </c:pt>
                <c:pt idx="347">
                  <c:v>0.41084</c:v>
                </c:pt>
                <c:pt idx="348">
                  <c:v>0.41143</c:v>
                </c:pt>
                <c:pt idx="349">
                  <c:v>0.41176</c:v>
                </c:pt>
                <c:pt idx="350">
                  <c:v>0.41791</c:v>
                </c:pt>
                <c:pt idx="351">
                  <c:v>0.41916</c:v>
                </c:pt>
                <c:pt idx="352">
                  <c:v>0.42222</c:v>
                </c:pt>
                <c:pt idx="353">
                  <c:v>0.42274</c:v>
                </c:pt>
                <c:pt idx="354">
                  <c:v>0.43031</c:v>
                </c:pt>
                <c:pt idx="355">
                  <c:v>0.43514</c:v>
                </c:pt>
                <c:pt idx="356">
                  <c:v>0.44809</c:v>
                </c:pt>
                <c:pt idx="357">
                  <c:v>0.45513</c:v>
                </c:pt>
                <c:pt idx="358">
                  <c:v>0.45949</c:v>
                </c:pt>
                <c:pt idx="359">
                  <c:v>0.46067</c:v>
                </c:pt>
                <c:pt idx="360">
                  <c:v>0.46256</c:v>
                </c:pt>
                <c:pt idx="361">
                  <c:v>0.46488</c:v>
                </c:pt>
                <c:pt idx="362">
                  <c:v>0.46503</c:v>
                </c:pt>
                <c:pt idx="363">
                  <c:v>0.46825</c:v>
                </c:pt>
                <c:pt idx="364">
                  <c:v>0.46922</c:v>
                </c:pt>
                <c:pt idx="365">
                  <c:v>0.47027</c:v>
                </c:pt>
                <c:pt idx="366">
                  <c:v>0.47059</c:v>
                </c:pt>
                <c:pt idx="367">
                  <c:v>0.47134</c:v>
                </c:pt>
                <c:pt idx="368">
                  <c:v>0.47153</c:v>
                </c:pt>
                <c:pt idx="369">
                  <c:v>0.4717</c:v>
                </c:pt>
                <c:pt idx="370">
                  <c:v>0.47317</c:v>
                </c:pt>
                <c:pt idx="371">
                  <c:v>0.4814</c:v>
                </c:pt>
                <c:pt idx="372">
                  <c:v>0.48387</c:v>
                </c:pt>
                <c:pt idx="373">
                  <c:v>0.48659</c:v>
                </c:pt>
                <c:pt idx="374">
                  <c:v>0.48742</c:v>
                </c:pt>
                <c:pt idx="375">
                  <c:v>0.48889</c:v>
                </c:pt>
                <c:pt idx="376">
                  <c:v>0.49109</c:v>
                </c:pt>
                <c:pt idx="377">
                  <c:v>0.49642</c:v>
                </c:pt>
                <c:pt idx="378">
                  <c:v>0.49766</c:v>
                </c:pt>
                <c:pt idx="379">
                  <c:v>0.5</c:v>
                </c:pt>
                <c:pt idx="380">
                  <c:v>0.50231</c:v>
                </c:pt>
                <c:pt idx="381">
                  <c:v>0.50769</c:v>
                </c:pt>
                <c:pt idx="382">
                  <c:v>0.51261</c:v>
                </c:pt>
                <c:pt idx="383">
                  <c:v>0.51502</c:v>
                </c:pt>
                <c:pt idx="384">
                  <c:v>0.51706</c:v>
                </c:pt>
                <c:pt idx="385">
                  <c:v>0.52632</c:v>
                </c:pt>
                <c:pt idx="386">
                  <c:v>0.52732</c:v>
                </c:pt>
                <c:pt idx="387">
                  <c:v>0.52982</c:v>
                </c:pt>
                <c:pt idx="388">
                  <c:v>0.5305</c:v>
                </c:pt>
                <c:pt idx="389">
                  <c:v>0.54545</c:v>
                </c:pt>
                <c:pt idx="390">
                  <c:v>0.54713</c:v>
                </c:pt>
                <c:pt idx="391">
                  <c:v>0.55283</c:v>
                </c:pt>
                <c:pt idx="392">
                  <c:v>0.55432</c:v>
                </c:pt>
                <c:pt idx="393">
                  <c:v>0.55501</c:v>
                </c:pt>
                <c:pt idx="394">
                  <c:v>0.55822</c:v>
                </c:pt>
                <c:pt idx="395">
                  <c:v>0.56311</c:v>
                </c:pt>
                <c:pt idx="396">
                  <c:v>0.56694</c:v>
                </c:pt>
                <c:pt idx="397">
                  <c:v>0.57947</c:v>
                </c:pt>
                <c:pt idx="398">
                  <c:v>0.58160237388724</c:v>
                </c:pt>
                <c:pt idx="399">
                  <c:v>0.58199</c:v>
                </c:pt>
                <c:pt idx="400">
                  <c:v>0.58934</c:v>
                </c:pt>
                <c:pt idx="401">
                  <c:v>0.5919</c:v>
                </c:pt>
                <c:pt idx="402">
                  <c:v>0.59528</c:v>
                </c:pt>
                <c:pt idx="403">
                  <c:v>0.5974</c:v>
                </c:pt>
                <c:pt idx="404">
                  <c:v>0.60385</c:v>
                </c:pt>
                <c:pt idx="405">
                  <c:v>0.61338</c:v>
                </c:pt>
                <c:pt idx="406">
                  <c:v>0.62037</c:v>
                </c:pt>
                <c:pt idx="407">
                  <c:v>0.6231</c:v>
                </c:pt>
                <c:pt idx="408">
                  <c:v>0.62473</c:v>
                </c:pt>
                <c:pt idx="409">
                  <c:v>0.63719</c:v>
                </c:pt>
                <c:pt idx="410">
                  <c:v>0.64671</c:v>
                </c:pt>
                <c:pt idx="411">
                  <c:v>0.64796</c:v>
                </c:pt>
                <c:pt idx="412">
                  <c:v>0.65421</c:v>
                </c:pt>
                <c:pt idx="413">
                  <c:v>0.65983</c:v>
                </c:pt>
                <c:pt idx="414">
                  <c:v>0.66187</c:v>
                </c:pt>
                <c:pt idx="415">
                  <c:v>0.67539</c:v>
                </c:pt>
                <c:pt idx="416">
                  <c:v>0.67671</c:v>
                </c:pt>
                <c:pt idx="417">
                  <c:v>0.67705</c:v>
                </c:pt>
                <c:pt idx="418">
                  <c:v>0.67828</c:v>
                </c:pt>
                <c:pt idx="419">
                  <c:v>0.7003</c:v>
                </c:pt>
                <c:pt idx="420">
                  <c:v>0.7094</c:v>
                </c:pt>
                <c:pt idx="421">
                  <c:v>0.72362</c:v>
                </c:pt>
                <c:pt idx="422">
                  <c:v>0.73115</c:v>
                </c:pt>
                <c:pt idx="423">
                  <c:v>0.73649</c:v>
                </c:pt>
                <c:pt idx="424">
                  <c:v>0.73874</c:v>
                </c:pt>
                <c:pt idx="425">
                  <c:v>0.74257</c:v>
                </c:pt>
                <c:pt idx="426">
                  <c:v>0.74429</c:v>
                </c:pt>
                <c:pt idx="427">
                  <c:v>0.75335</c:v>
                </c:pt>
                <c:pt idx="428">
                  <c:v>0.77228</c:v>
                </c:pt>
                <c:pt idx="429">
                  <c:v>0.77762</c:v>
                </c:pt>
                <c:pt idx="430">
                  <c:v>0.79974</c:v>
                </c:pt>
                <c:pt idx="431">
                  <c:v>0.82533</c:v>
                </c:pt>
                <c:pt idx="432">
                  <c:v>0.86366</c:v>
                </c:pt>
                <c:pt idx="433">
                  <c:v>0.896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</c:f>
              <c:strCache>
                <c:ptCount val="1"/>
                <c:pt idx="0">
                  <c:v>Private to primary</c:v>
                </c:pt>
              </c:strCache>
            </c:strRef>
          </c:tx>
          <c:spPr>
            <a:ln w="47625">
              <a:noFill/>
            </a:ln>
          </c:spPr>
          <c:marker>
            <c:symbol val="circle"/>
            <c:size val="6"/>
            <c:spPr>
              <a:solidFill>
                <a:schemeClr val="accent2">
                  <a:lumMod val="40000"/>
                  <a:lumOff val="60000"/>
                </a:schemeClr>
              </a:solidFill>
            </c:spPr>
          </c:marker>
          <c:xVal>
            <c:numRef>
              <c:f>Sheet1!$E$2:$E$435</c:f>
              <c:numCache>
                <c:formatCode>General</c:formatCode>
                <c:ptCount val="434"/>
                <c:pt idx="0">
                  <c:v>0.04141</c:v>
                </c:pt>
                <c:pt idx="1">
                  <c:v>0.05051</c:v>
                </c:pt>
                <c:pt idx="2">
                  <c:v>0.05164</c:v>
                </c:pt>
                <c:pt idx="3">
                  <c:v>0.05347</c:v>
                </c:pt>
                <c:pt idx="4">
                  <c:v>0.05373</c:v>
                </c:pt>
                <c:pt idx="5">
                  <c:v>0.05946</c:v>
                </c:pt>
                <c:pt idx="6">
                  <c:v>0.06163</c:v>
                </c:pt>
                <c:pt idx="7">
                  <c:v>0.06203</c:v>
                </c:pt>
                <c:pt idx="8">
                  <c:v>0.07507</c:v>
                </c:pt>
                <c:pt idx="9">
                  <c:v>0.08626</c:v>
                </c:pt>
                <c:pt idx="10">
                  <c:v>0.08629</c:v>
                </c:pt>
                <c:pt idx="11">
                  <c:v>0.08706</c:v>
                </c:pt>
                <c:pt idx="12">
                  <c:v>0.09113</c:v>
                </c:pt>
                <c:pt idx="13">
                  <c:v>0.09412</c:v>
                </c:pt>
                <c:pt idx="14">
                  <c:v>0.09496</c:v>
                </c:pt>
                <c:pt idx="15">
                  <c:v>0.12346</c:v>
                </c:pt>
                <c:pt idx="16">
                  <c:v>0.1345</c:v>
                </c:pt>
                <c:pt idx="17">
                  <c:v>0.17078</c:v>
                </c:pt>
                <c:pt idx="18">
                  <c:v>0.18056</c:v>
                </c:pt>
                <c:pt idx="19">
                  <c:v>0.18542</c:v>
                </c:pt>
                <c:pt idx="20">
                  <c:v>0.18644</c:v>
                </c:pt>
                <c:pt idx="21">
                  <c:v>0.215</c:v>
                </c:pt>
                <c:pt idx="22">
                  <c:v>0.21883</c:v>
                </c:pt>
                <c:pt idx="23">
                  <c:v>0.28336</c:v>
                </c:pt>
                <c:pt idx="24">
                  <c:v>0.28794</c:v>
                </c:pt>
                <c:pt idx="25">
                  <c:v>0.28814</c:v>
                </c:pt>
                <c:pt idx="26">
                  <c:v>0.29331</c:v>
                </c:pt>
                <c:pt idx="27">
                  <c:v>0.31429</c:v>
                </c:pt>
                <c:pt idx="28">
                  <c:v>0.35994</c:v>
                </c:pt>
                <c:pt idx="29">
                  <c:v>0.4376</c:v>
                </c:pt>
                <c:pt idx="30">
                  <c:v>0.53008</c:v>
                </c:pt>
                <c:pt idx="31">
                  <c:v>0.55236</c:v>
                </c:pt>
                <c:pt idx="32">
                  <c:v>0.27101</c:v>
                </c:pt>
                <c:pt idx="33">
                  <c:v>0.07298</c:v>
                </c:pt>
                <c:pt idx="34">
                  <c:v>0.12541</c:v>
                </c:pt>
                <c:pt idx="35">
                  <c:v>0.09327</c:v>
                </c:pt>
                <c:pt idx="36">
                  <c:v>0.12667</c:v>
                </c:pt>
                <c:pt idx="37">
                  <c:v>0.13084</c:v>
                </c:pt>
                <c:pt idx="38">
                  <c:v>0.19682</c:v>
                </c:pt>
                <c:pt idx="39">
                  <c:v>0.20497</c:v>
                </c:pt>
                <c:pt idx="40">
                  <c:v>0.053</c:v>
                </c:pt>
                <c:pt idx="41">
                  <c:v>0.14082</c:v>
                </c:pt>
                <c:pt idx="42">
                  <c:v>0.19668</c:v>
                </c:pt>
                <c:pt idx="43">
                  <c:v>0.14019</c:v>
                </c:pt>
                <c:pt idx="44">
                  <c:v>0.27094</c:v>
                </c:pt>
                <c:pt idx="45">
                  <c:v>0.23973</c:v>
                </c:pt>
                <c:pt idx="46">
                  <c:v>0.1994</c:v>
                </c:pt>
              </c:numCache>
            </c:numRef>
          </c:xVal>
          <c:yVal>
            <c:numRef>
              <c:f>Sheet1!$D$2:$D$435</c:f>
              <c:numCache>
                <c:formatCode>General</c:formatCode>
                <c:ptCount val="43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0072</c:v>
                </c:pt>
                <c:pt idx="33">
                  <c:v>0.00103</c:v>
                </c:pt>
                <c:pt idx="34">
                  <c:v>0.00125</c:v>
                </c:pt>
                <c:pt idx="35">
                  <c:v>0.0014</c:v>
                </c:pt>
                <c:pt idx="36">
                  <c:v>0.00147</c:v>
                </c:pt>
                <c:pt idx="37">
                  <c:v>0.0017</c:v>
                </c:pt>
                <c:pt idx="38">
                  <c:v>0.00188</c:v>
                </c:pt>
                <c:pt idx="39">
                  <c:v>0.00262</c:v>
                </c:pt>
                <c:pt idx="40">
                  <c:v>0.00274</c:v>
                </c:pt>
                <c:pt idx="41">
                  <c:v>0.00277</c:v>
                </c:pt>
                <c:pt idx="42">
                  <c:v>0.00287</c:v>
                </c:pt>
                <c:pt idx="43">
                  <c:v>0.00402</c:v>
                </c:pt>
                <c:pt idx="44">
                  <c:v>0.00451</c:v>
                </c:pt>
                <c:pt idx="45">
                  <c:v>0.00556</c:v>
                </c:pt>
                <c:pt idx="46">
                  <c:v>0.00731</c:v>
                </c:pt>
                <c:pt idx="47">
                  <c:v>0.02055</c:v>
                </c:pt>
                <c:pt idx="48">
                  <c:v>0.03595</c:v>
                </c:pt>
                <c:pt idx="49">
                  <c:v>0.0366</c:v>
                </c:pt>
                <c:pt idx="50">
                  <c:v>0.04555</c:v>
                </c:pt>
                <c:pt idx="51">
                  <c:v>0.0458</c:v>
                </c:pt>
                <c:pt idx="52">
                  <c:v>0.04847</c:v>
                </c:pt>
                <c:pt idx="53">
                  <c:v>0.0495</c:v>
                </c:pt>
                <c:pt idx="54">
                  <c:v>0.0515</c:v>
                </c:pt>
                <c:pt idx="55">
                  <c:v>0.05376</c:v>
                </c:pt>
                <c:pt idx="56">
                  <c:v>0.05443</c:v>
                </c:pt>
                <c:pt idx="57">
                  <c:v>0.05498</c:v>
                </c:pt>
                <c:pt idx="58">
                  <c:v>0.0557</c:v>
                </c:pt>
                <c:pt idx="59">
                  <c:v>0.05652</c:v>
                </c:pt>
                <c:pt idx="60">
                  <c:v>0.05699</c:v>
                </c:pt>
                <c:pt idx="61">
                  <c:v>0.05992</c:v>
                </c:pt>
                <c:pt idx="62">
                  <c:v>0.06154</c:v>
                </c:pt>
                <c:pt idx="63">
                  <c:v>0.06271</c:v>
                </c:pt>
                <c:pt idx="64">
                  <c:v>0.06393</c:v>
                </c:pt>
                <c:pt idx="65">
                  <c:v>0.06442</c:v>
                </c:pt>
                <c:pt idx="66">
                  <c:v>0.06522</c:v>
                </c:pt>
                <c:pt idx="67">
                  <c:v>0.06731</c:v>
                </c:pt>
                <c:pt idx="68">
                  <c:v>0.06882</c:v>
                </c:pt>
                <c:pt idx="69">
                  <c:v>0.07249</c:v>
                </c:pt>
                <c:pt idx="70">
                  <c:v>0.07282</c:v>
                </c:pt>
                <c:pt idx="71">
                  <c:v>0.07888</c:v>
                </c:pt>
                <c:pt idx="72">
                  <c:v>0.08173</c:v>
                </c:pt>
                <c:pt idx="73">
                  <c:v>0.08483</c:v>
                </c:pt>
                <c:pt idx="74">
                  <c:v>0.08644</c:v>
                </c:pt>
                <c:pt idx="75">
                  <c:v>0.08861</c:v>
                </c:pt>
                <c:pt idx="76">
                  <c:v>0.08868</c:v>
                </c:pt>
                <c:pt idx="77">
                  <c:v>0.09016</c:v>
                </c:pt>
                <c:pt idx="78">
                  <c:v>0.09031</c:v>
                </c:pt>
                <c:pt idx="79">
                  <c:v>0.09091</c:v>
                </c:pt>
                <c:pt idx="80">
                  <c:v>0.09164</c:v>
                </c:pt>
                <c:pt idx="81">
                  <c:v>0.09228</c:v>
                </c:pt>
                <c:pt idx="82">
                  <c:v>0.09467</c:v>
                </c:pt>
                <c:pt idx="83">
                  <c:v>0.09496</c:v>
                </c:pt>
                <c:pt idx="84">
                  <c:v>0.09617</c:v>
                </c:pt>
                <c:pt idx="85">
                  <c:v>0.09656</c:v>
                </c:pt>
                <c:pt idx="86">
                  <c:v>0.09754</c:v>
                </c:pt>
                <c:pt idx="87">
                  <c:v>0.10244</c:v>
                </c:pt>
                <c:pt idx="88">
                  <c:v>0.10325</c:v>
                </c:pt>
                <c:pt idx="89">
                  <c:v>0.10335</c:v>
                </c:pt>
                <c:pt idx="90">
                  <c:v>0.10383</c:v>
                </c:pt>
                <c:pt idx="91">
                  <c:v>0.10788</c:v>
                </c:pt>
                <c:pt idx="92">
                  <c:v>0.10811</c:v>
                </c:pt>
                <c:pt idx="93">
                  <c:v>0.10887</c:v>
                </c:pt>
                <c:pt idx="94">
                  <c:v>0.11256</c:v>
                </c:pt>
                <c:pt idx="95">
                  <c:v>0.11619</c:v>
                </c:pt>
                <c:pt idx="96">
                  <c:v>0.117</c:v>
                </c:pt>
                <c:pt idx="97">
                  <c:v>0.11725</c:v>
                </c:pt>
                <c:pt idx="98">
                  <c:v>0.11735</c:v>
                </c:pt>
                <c:pt idx="99">
                  <c:v>0.12121</c:v>
                </c:pt>
                <c:pt idx="100">
                  <c:v>0.12321</c:v>
                </c:pt>
                <c:pt idx="101">
                  <c:v>0.12403</c:v>
                </c:pt>
                <c:pt idx="102">
                  <c:v>0.1246</c:v>
                </c:pt>
                <c:pt idx="103">
                  <c:v>0.1281</c:v>
                </c:pt>
                <c:pt idx="104">
                  <c:v>0.12861</c:v>
                </c:pt>
                <c:pt idx="105">
                  <c:v>0.12927</c:v>
                </c:pt>
                <c:pt idx="106">
                  <c:v>0.12935</c:v>
                </c:pt>
                <c:pt idx="107">
                  <c:v>0.12991</c:v>
                </c:pt>
                <c:pt idx="108">
                  <c:v>0.13129</c:v>
                </c:pt>
                <c:pt idx="109">
                  <c:v>0.13237</c:v>
                </c:pt>
                <c:pt idx="110">
                  <c:v>0.1336</c:v>
                </c:pt>
                <c:pt idx="111">
                  <c:v>0.13408</c:v>
                </c:pt>
                <c:pt idx="112">
                  <c:v>0.13552</c:v>
                </c:pt>
                <c:pt idx="113">
                  <c:v>0.13682</c:v>
                </c:pt>
                <c:pt idx="114">
                  <c:v>0.13939</c:v>
                </c:pt>
                <c:pt idx="115">
                  <c:v>0.14038</c:v>
                </c:pt>
                <c:pt idx="116">
                  <c:v>0.14062</c:v>
                </c:pt>
                <c:pt idx="117">
                  <c:v>0.14267</c:v>
                </c:pt>
                <c:pt idx="118">
                  <c:v>0.14286</c:v>
                </c:pt>
                <c:pt idx="119">
                  <c:v>0.14331</c:v>
                </c:pt>
                <c:pt idx="120">
                  <c:v>0.14408</c:v>
                </c:pt>
                <c:pt idx="121">
                  <c:v>0.14599</c:v>
                </c:pt>
                <c:pt idx="122">
                  <c:v>0.14653</c:v>
                </c:pt>
                <c:pt idx="123">
                  <c:v>0.14841</c:v>
                </c:pt>
                <c:pt idx="124">
                  <c:v>0.14847</c:v>
                </c:pt>
                <c:pt idx="125">
                  <c:v>0.15198</c:v>
                </c:pt>
                <c:pt idx="126">
                  <c:v>0.15244</c:v>
                </c:pt>
                <c:pt idx="127">
                  <c:v>0.15328</c:v>
                </c:pt>
                <c:pt idx="128">
                  <c:v>0.15432</c:v>
                </c:pt>
                <c:pt idx="129">
                  <c:v>0.15975</c:v>
                </c:pt>
                <c:pt idx="130">
                  <c:v>0.16049</c:v>
                </c:pt>
                <c:pt idx="131">
                  <c:v>0.16052</c:v>
                </c:pt>
                <c:pt idx="132">
                  <c:v>0.16159</c:v>
                </c:pt>
                <c:pt idx="133">
                  <c:v>0.16169</c:v>
                </c:pt>
                <c:pt idx="134">
                  <c:v>0.16242</c:v>
                </c:pt>
                <c:pt idx="135">
                  <c:v>0.16361</c:v>
                </c:pt>
                <c:pt idx="136">
                  <c:v>0.16507</c:v>
                </c:pt>
                <c:pt idx="137">
                  <c:v>0.16523</c:v>
                </c:pt>
                <c:pt idx="138">
                  <c:v>0.16623</c:v>
                </c:pt>
                <c:pt idx="139">
                  <c:v>0.17226</c:v>
                </c:pt>
                <c:pt idx="140">
                  <c:v>0.17361</c:v>
                </c:pt>
                <c:pt idx="141">
                  <c:v>0.17391</c:v>
                </c:pt>
                <c:pt idx="142">
                  <c:v>0.17559</c:v>
                </c:pt>
                <c:pt idx="143">
                  <c:v>0.17586</c:v>
                </c:pt>
                <c:pt idx="144">
                  <c:v>0.1759</c:v>
                </c:pt>
                <c:pt idx="145">
                  <c:v>0.17797</c:v>
                </c:pt>
                <c:pt idx="146">
                  <c:v>0.17804</c:v>
                </c:pt>
                <c:pt idx="147">
                  <c:v>0.17904</c:v>
                </c:pt>
                <c:pt idx="148">
                  <c:v>0.18027</c:v>
                </c:pt>
                <c:pt idx="149">
                  <c:v>0.18041</c:v>
                </c:pt>
                <c:pt idx="150">
                  <c:v>0.18063</c:v>
                </c:pt>
                <c:pt idx="151">
                  <c:v>0.18182</c:v>
                </c:pt>
                <c:pt idx="152">
                  <c:v>0.18182</c:v>
                </c:pt>
                <c:pt idx="153">
                  <c:v>0.18411</c:v>
                </c:pt>
                <c:pt idx="154">
                  <c:v>0.18436</c:v>
                </c:pt>
                <c:pt idx="155">
                  <c:v>0.18458</c:v>
                </c:pt>
                <c:pt idx="156">
                  <c:v>0.18552</c:v>
                </c:pt>
                <c:pt idx="157">
                  <c:v>0.1866</c:v>
                </c:pt>
                <c:pt idx="158">
                  <c:v>0.187</c:v>
                </c:pt>
                <c:pt idx="159">
                  <c:v>0.18739</c:v>
                </c:pt>
                <c:pt idx="160">
                  <c:v>0.18803</c:v>
                </c:pt>
                <c:pt idx="161">
                  <c:v>0.18826</c:v>
                </c:pt>
                <c:pt idx="162">
                  <c:v>0.18896</c:v>
                </c:pt>
                <c:pt idx="163">
                  <c:v>0.18913</c:v>
                </c:pt>
                <c:pt idx="164">
                  <c:v>0.18949</c:v>
                </c:pt>
                <c:pt idx="165">
                  <c:v>0.18993</c:v>
                </c:pt>
                <c:pt idx="166">
                  <c:v>0.19048</c:v>
                </c:pt>
                <c:pt idx="167">
                  <c:v>0.19086</c:v>
                </c:pt>
                <c:pt idx="168">
                  <c:v>0.19302</c:v>
                </c:pt>
                <c:pt idx="169">
                  <c:v>0.1944</c:v>
                </c:pt>
                <c:pt idx="170">
                  <c:v>0.19448</c:v>
                </c:pt>
                <c:pt idx="171">
                  <c:v>0.19512</c:v>
                </c:pt>
                <c:pt idx="172">
                  <c:v>0.19562</c:v>
                </c:pt>
                <c:pt idx="173">
                  <c:v>0.19623</c:v>
                </c:pt>
                <c:pt idx="174">
                  <c:v>0.19634</c:v>
                </c:pt>
                <c:pt idx="175">
                  <c:v>0.19697</c:v>
                </c:pt>
                <c:pt idx="176">
                  <c:v>0.19856</c:v>
                </c:pt>
                <c:pt idx="177">
                  <c:v>0.2</c:v>
                </c:pt>
                <c:pt idx="178">
                  <c:v>0.20064</c:v>
                </c:pt>
                <c:pt idx="179">
                  <c:v>0.20137</c:v>
                </c:pt>
                <c:pt idx="180">
                  <c:v>0.20225</c:v>
                </c:pt>
                <c:pt idx="181">
                  <c:v>0.20359</c:v>
                </c:pt>
                <c:pt idx="182">
                  <c:v>0.2038</c:v>
                </c:pt>
                <c:pt idx="183">
                  <c:v>0.20488</c:v>
                </c:pt>
                <c:pt idx="184">
                  <c:v>0.20519</c:v>
                </c:pt>
                <c:pt idx="185">
                  <c:v>0.20708</c:v>
                </c:pt>
                <c:pt idx="186">
                  <c:v>0.20833</c:v>
                </c:pt>
                <c:pt idx="187">
                  <c:v>0.2102</c:v>
                </c:pt>
                <c:pt idx="188">
                  <c:v>0.21068</c:v>
                </c:pt>
                <c:pt idx="189">
                  <c:v>0.21212</c:v>
                </c:pt>
                <c:pt idx="190">
                  <c:v>0.21301</c:v>
                </c:pt>
                <c:pt idx="191">
                  <c:v>0.21562</c:v>
                </c:pt>
                <c:pt idx="192">
                  <c:v>0.21764</c:v>
                </c:pt>
                <c:pt idx="193">
                  <c:v>0.21771</c:v>
                </c:pt>
                <c:pt idx="194">
                  <c:v>0.21794</c:v>
                </c:pt>
                <c:pt idx="195">
                  <c:v>0.21884</c:v>
                </c:pt>
                <c:pt idx="196">
                  <c:v>0.21887</c:v>
                </c:pt>
                <c:pt idx="197">
                  <c:v>0.22209</c:v>
                </c:pt>
                <c:pt idx="198">
                  <c:v>0.22308</c:v>
                </c:pt>
                <c:pt idx="199">
                  <c:v>0.22449</c:v>
                </c:pt>
                <c:pt idx="200">
                  <c:v>0.22449</c:v>
                </c:pt>
                <c:pt idx="201">
                  <c:v>0.225</c:v>
                </c:pt>
                <c:pt idx="202">
                  <c:v>0.22535</c:v>
                </c:pt>
                <c:pt idx="203">
                  <c:v>0.225769669327252</c:v>
                </c:pt>
                <c:pt idx="204">
                  <c:v>0.22592</c:v>
                </c:pt>
                <c:pt idx="205">
                  <c:v>0.22642</c:v>
                </c:pt>
                <c:pt idx="206">
                  <c:v>0.22669</c:v>
                </c:pt>
                <c:pt idx="207">
                  <c:v>0.22694</c:v>
                </c:pt>
                <c:pt idx="208">
                  <c:v>0.23144</c:v>
                </c:pt>
                <c:pt idx="209">
                  <c:v>0.23223</c:v>
                </c:pt>
                <c:pt idx="210">
                  <c:v>0.2335</c:v>
                </c:pt>
                <c:pt idx="211">
                  <c:v>0.2348</c:v>
                </c:pt>
                <c:pt idx="212">
                  <c:v>0.23688</c:v>
                </c:pt>
                <c:pt idx="213">
                  <c:v>0.2373</c:v>
                </c:pt>
                <c:pt idx="214">
                  <c:v>0.23734</c:v>
                </c:pt>
                <c:pt idx="215">
                  <c:v>0.2398</c:v>
                </c:pt>
                <c:pt idx="216">
                  <c:v>0.23982</c:v>
                </c:pt>
                <c:pt idx="217">
                  <c:v>0.24</c:v>
                </c:pt>
                <c:pt idx="218">
                  <c:v>0.24152</c:v>
                </c:pt>
                <c:pt idx="219">
                  <c:v>0.24297</c:v>
                </c:pt>
                <c:pt idx="220">
                  <c:v>0.24302</c:v>
                </c:pt>
                <c:pt idx="221">
                  <c:v>0.24312</c:v>
                </c:pt>
                <c:pt idx="222">
                  <c:v>0.24514</c:v>
                </c:pt>
                <c:pt idx="223">
                  <c:v>0.24542</c:v>
                </c:pt>
                <c:pt idx="224">
                  <c:v>0.24583</c:v>
                </c:pt>
                <c:pt idx="225">
                  <c:v>0.24612</c:v>
                </c:pt>
                <c:pt idx="226">
                  <c:v>0.24642</c:v>
                </c:pt>
                <c:pt idx="227">
                  <c:v>0.24736</c:v>
                </c:pt>
                <c:pt idx="228">
                  <c:v>0.24837</c:v>
                </c:pt>
                <c:pt idx="229">
                  <c:v>0.24961</c:v>
                </c:pt>
                <c:pt idx="230">
                  <c:v>0.25243</c:v>
                </c:pt>
                <c:pt idx="231">
                  <c:v>0.25393</c:v>
                </c:pt>
                <c:pt idx="232">
                  <c:v>0.25397</c:v>
                </c:pt>
                <c:pt idx="233">
                  <c:v>0.25427</c:v>
                </c:pt>
                <c:pt idx="234">
                  <c:v>0.25694</c:v>
                </c:pt>
                <c:pt idx="235">
                  <c:v>0.26049</c:v>
                </c:pt>
                <c:pt idx="236">
                  <c:v>0.26068</c:v>
                </c:pt>
                <c:pt idx="237">
                  <c:v>0.26075</c:v>
                </c:pt>
                <c:pt idx="238">
                  <c:v>0.26102</c:v>
                </c:pt>
                <c:pt idx="239">
                  <c:v>0.26431</c:v>
                </c:pt>
                <c:pt idx="240">
                  <c:v>0.26437</c:v>
                </c:pt>
                <c:pt idx="241">
                  <c:v>0.26715</c:v>
                </c:pt>
                <c:pt idx="242">
                  <c:v>0.26767</c:v>
                </c:pt>
                <c:pt idx="243">
                  <c:v>0.26775</c:v>
                </c:pt>
                <c:pt idx="244">
                  <c:v>0.2681</c:v>
                </c:pt>
                <c:pt idx="245">
                  <c:v>0.27195</c:v>
                </c:pt>
                <c:pt idx="246">
                  <c:v>0.27425</c:v>
                </c:pt>
                <c:pt idx="247">
                  <c:v>0.27559</c:v>
                </c:pt>
                <c:pt idx="248">
                  <c:v>0.2757</c:v>
                </c:pt>
                <c:pt idx="249">
                  <c:v>0.27633</c:v>
                </c:pt>
                <c:pt idx="250">
                  <c:v>0.2779</c:v>
                </c:pt>
                <c:pt idx="251">
                  <c:v>0.27981</c:v>
                </c:pt>
                <c:pt idx="252">
                  <c:v>0.28045</c:v>
                </c:pt>
                <c:pt idx="253">
                  <c:v>0.28436</c:v>
                </c:pt>
                <c:pt idx="254">
                  <c:v>0.28539</c:v>
                </c:pt>
                <c:pt idx="255">
                  <c:v>0.28571</c:v>
                </c:pt>
                <c:pt idx="256">
                  <c:v>0.28683</c:v>
                </c:pt>
                <c:pt idx="257">
                  <c:v>0.28707</c:v>
                </c:pt>
                <c:pt idx="258">
                  <c:v>0.28808</c:v>
                </c:pt>
                <c:pt idx="259">
                  <c:v>0.29014</c:v>
                </c:pt>
                <c:pt idx="260">
                  <c:v>0.29093</c:v>
                </c:pt>
                <c:pt idx="261">
                  <c:v>0.29217</c:v>
                </c:pt>
                <c:pt idx="262">
                  <c:v>0.29228</c:v>
                </c:pt>
                <c:pt idx="263">
                  <c:v>0.29229</c:v>
                </c:pt>
                <c:pt idx="264">
                  <c:v>0.29348</c:v>
                </c:pt>
                <c:pt idx="265">
                  <c:v>0.29412</c:v>
                </c:pt>
                <c:pt idx="266">
                  <c:v>0.29412</c:v>
                </c:pt>
                <c:pt idx="267">
                  <c:v>0.29454</c:v>
                </c:pt>
                <c:pt idx="268">
                  <c:v>0.297619047619048</c:v>
                </c:pt>
                <c:pt idx="269">
                  <c:v>0.29907</c:v>
                </c:pt>
                <c:pt idx="270">
                  <c:v>0.30352</c:v>
                </c:pt>
                <c:pt idx="271">
                  <c:v>0.30409</c:v>
                </c:pt>
                <c:pt idx="272">
                  <c:v>0.30423</c:v>
                </c:pt>
                <c:pt idx="273">
                  <c:v>0.30481</c:v>
                </c:pt>
                <c:pt idx="274">
                  <c:v>0.30488</c:v>
                </c:pt>
                <c:pt idx="275">
                  <c:v>0.3085</c:v>
                </c:pt>
                <c:pt idx="276">
                  <c:v>0.31014</c:v>
                </c:pt>
                <c:pt idx="277">
                  <c:v>0.31291</c:v>
                </c:pt>
                <c:pt idx="278">
                  <c:v>0.31314</c:v>
                </c:pt>
                <c:pt idx="279">
                  <c:v>0.31389</c:v>
                </c:pt>
                <c:pt idx="280">
                  <c:v>0.31915</c:v>
                </c:pt>
                <c:pt idx="281">
                  <c:v>0.32222</c:v>
                </c:pt>
                <c:pt idx="282">
                  <c:v>0.32317</c:v>
                </c:pt>
                <c:pt idx="283">
                  <c:v>0.3232</c:v>
                </c:pt>
                <c:pt idx="284">
                  <c:v>0.3275</c:v>
                </c:pt>
                <c:pt idx="285">
                  <c:v>0.3279</c:v>
                </c:pt>
                <c:pt idx="286">
                  <c:v>0.3284</c:v>
                </c:pt>
                <c:pt idx="287">
                  <c:v>0.33155</c:v>
                </c:pt>
                <c:pt idx="288">
                  <c:v>0.33483</c:v>
                </c:pt>
                <c:pt idx="289">
                  <c:v>0.33526</c:v>
                </c:pt>
                <c:pt idx="290">
                  <c:v>0.33537</c:v>
                </c:pt>
                <c:pt idx="291">
                  <c:v>0.33626</c:v>
                </c:pt>
                <c:pt idx="292">
                  <c:v>0.33698</c:v>
                </c:pt>
                <c:pt idx="293">
                  <c:v>0.33714</c:v>
                </c:pt>
                <c:pt idx="294">
                  <c:v>0.33977</c:v>
                </c:pt>
                <c:pt idx="295">
                  <c:v>0.33987</c:v>
                </c:pt>
                <c:pt idx="296">
                  <c:v>0.34017</c:v>
                </c:pt>
                <c:pt idx="297">
                  <c:v>0.34209</c:v>
                </c:pt>
                <c:pt idx="298">
                  <c:v>0.34421</c:v>
                </c:pt>
                <c:pt idx="299">
                  <c:v>0.34532</c:v>
                </c:pt>
                <c:pt idx="300">
                  <c:v>0.34544</c:v>
                </c:pt>
                <c:pt idx="301">
                  <c:v>0.34711</c:v>
                </c:pt>
                <c:pt idx="302">
                  <c:v>0.34756</c:v>
                </c:pt>
                <c:pt idx="303">
                  <c:v>0.34796</c:v>
                </c:pt>
                <c:pt idx="304">
                  <c:v>0.34844</c:v>
                </c:pt>
                <c:pt idx="305">
                  <c:v>0.34945</c:v>
                </c:pt>
                <c:pt idx="306">
                  <c:v>0.35003</c:v>
                </c:pt>
                <c:pt idx="307">
                  <c:v>0.35117</c:v>
                </c:pt>
                <c:pt idx="308">
                  <c:v>0.35388</c:v>
                </c:pt>
                <c:pt idx="309">
                  <c:v>0.35995</c:v>
                </c:pt>
                <c:pt idx="310">
                  <c:v>0.36096</c:v>
                </c:pt>
                <c:pt idx="311">
                  <c:v>0.36134</c:v>
                </c:pt>
                <c:pt idx="312">
                  <c:v>0.36187</c:v>
                </c:pt>
                <c:pt idx="313">
                  <c:v>0.36275</c:v>
                </c:pt>
                <c:pt idx="314">
                  <c:v>0.36289</c:v>
                </c:pt>
                <c:pt idx="315">
                  <c:v>0.36364</c:v>
                </c:pt>
                <c:pt idx="316">
                  <c:v>0.36467</c:v>
                </c:pt>
                <c:pt idx="317">
                  <c:v>0.36472</c:v>
                </c:pt>
                <c:pt idx="318">
                  <c:v>0.36516</c:v>
                </c:pt>
                <c:pt idx="319">
                  <c:v>0.36686</c:v>
                </c:pt>
                <c:pt idx="320">
                  <c:v>0.36742</c:v>
                </c:pt>
                <c:pt idx="321">
                  <c:v>0.37073</c:v>
                </c:pt>
                <c:pt idx="322">
                  <c:v>0.37118</c:v>
                </c:pt>
                <c:pt idx="323">
                  <c:v>0.37187</c:v>
                </c:pt>
                <c:pt idx="324">
                  <c:v>0.37193</c:v>
                </c:pt>
                <c:pt idx="325">
                  <c:v>0.37209</c:v>
                </c:pt>
                <c:pt idx="326">
                  <c:v>0.37438</c:v>
                </c:pt>
                <c:pt idx="327">
                  <c:v>0.37604</c:v>
                </c:pt>
                <c:pt idx="328">
                  <c:v>0.37634</c:v>
                </c:pt>
                <c:pt idx="329">
                  <c:v>0.37965</c:v>
                </c:pt>
                <c:pt idx="330">
                  <c:v>0.38025</c:v>
                </c:pt>
                <c:pt idx="331">
                  <c:v>0.38079</c:v>
                </c:pt>
                <c:pt idx="332">
                  <c:v>0.38626</c:v>
                </c:pt>
                <c:pt idx="333">
                  <c:v>0.3865</c:v>
                </c:pt>
                <c:pt idx="334">
                  <c:v>0.38746</c:v>
                </c:pt>
                <c:pt idx="335">
                  <c:v>0.38909</c:v>
                </c:pt>
                <c:pt idx="336">
                  <c:v>0.39227</c:v>
                </c:pt>
                <c:pt idx="337">
                  <c:v>0.39726</c:v>
                </c:pt>
                <c:pt idx="338">
                  <c:v>0.4</c:v>
                </c:pt>
                <c:pt idx="339">
                  <c:v>0.40164</c:v>
                </c:pt>
                <c:pt idx="340">
                  <c:v>0.40367</c:v>
                </c:pt>
                <c:pt idx="341">
                  <c:v>0.40456</c:v>
                </c:pt>
                <c:pt idx="342">
                  <c:v>0.40521</c:v>
                </c:pt>
                <c:pt idx="343">
                  <c:v>0.40741</c:v>
                </c:pt>
                <c:pt idx="344">
                  <c:v>0.40758</c:v>
                </c:pt>
                <c:pt idx="345">
                  <c:v>0.40842</c:v>
                </c:pt>
                <c:pt idx="346">
                  <c:v>0.40967</c:v>
                </c:pt>
                <c:pt idx="347">
                  <c:v>0.41084</c:v>
                </c:pt>
                <c:pt idx="348">
                  <c:v>0.41143</c:v>
                </c:pt>
                <c:pt idx="349">
                  <c:v>0.41176</c:v>
                </c:pt>
                <c:pt idx="350">
                  <c:v>0.41791</c:v>
                </c:pt>
                <c:pt idx="351">
                  <c:v>0.41916</c:v>
                </c:pt>
                <c:pt idx="352">
                  <c:v>0.42222</c:v>
                </c:pt>
                <c:pt idx="353">
                  <c:v>0.42274</c:v>
                </c:pt>
                <c:pt idx="354">
                  <c:v>0.43031</c:v>
                </c:pt>
                <c:pt idx="355">
                  <c:v>0.43514</c:v>
                </c:pt>
                <c:pt idx="356">
                  <c:v>0.44809</c:v>
                </c:pt>
                <c:pt idx="357">
                  <c:v>0.45513</c:v>
                </c:pt>
                <c:pt idx="358">
                  <c:v>0.45949</c:v>
                </c:pt>
                <c:pt idx="359">
                  <c:v>0.46067</c:v>
                </c:pt>
                <c:pt idx="360">
                  <c:v>0.46256</c:v>
                </c:pt>
                <c:pt idx="361">
                  <c:v>0.46488</c:v>
                </c:pt>
                <c:pt idx="362">
                  <c:v>0.46503</c:v>
                </c:pt>
                <c:pt idx="363">
                  <c:v>0.46825</c:v>
                </c:pt>
                <c:pt idx="364">
                  <c:v>0.46922</c:v>
                </c:pt>
                <c:pt idx="365">
                  <c:v>0.47027</c:v>
                </c:pt>
                <c:pt idx="366">
                  <c:v>0.47059</c:v>
                </c:pt>
                <c:pt idx="367">
                  <c:v>0.47134</c:v>
                </c:pt>
                <c:pt idx="368">
                  <c:v>0.47153</c:v>
                </c:pt>
                <c:pt idx="369">
                  <c:v>0.4717</c:v>
                </c:pt>
                <c:pt idx="370">
                  <c:v>0.47317</c:v>
                </c:pt>
                <c:pt idx="371">
                  <c:v>0.4814</c:v>
                </c:pt>
                <c:pt idx="372">
                  <c:v>0.48387</c:v>
                </c:pt>
                <c:pt idx="373">
                  <c:v>0.48659</c:v>
                </c:pt>
                <c:pt idx="374">
                  <c:v>0.48742</c:v>
                </c:pt>
                <c:pt idx="375">
                  <c:v>0.48889</c:v>
                </c:pt>
                <c:pt idx="376">
                  <c:v>0.49109</c:v>
                </c:pt>
                <c:pt idx="377">
                  <c:v>0.49642</c:v>
                </c:pt>
                <c:pt idx="378">
                  <c:v>0.49766</c:v>
                </c:pt>
                <c:pt idx="379">
                  <c:v>0.5</c:v>
                </c:pt>
                <c:pt idx="380">
                  <c:v>0.50231</c:v>
                </c:pt>
                <c:pt idx="381">
                  <c:v>0.50769</c:v>
                </c:pt>
                <c:pt idx="382">
                  <c:v>0.51261</c:v>
                </c:pt>
                <c:pt idx="383">
                  <c:v>0.51502</c:v>
                </c:pt>
                <c:pt idx="384">
                  <c:v>0.51706</c:v>
                </c:pt>
                <c:pt idx="385">
                  <c:v>0.52632</c:v>
                </c:pt>
                <c:pt idx="386">
                  <c:v>0.52732</c:v>
                </c:pt>
                <c:pt idx="387">
                  <c:v>0.52982</c:v>
                </c:pt>
                <c:pt idx="388">
                  <c:v>0.5305</c:v>
                </c:pt>
                <c:pt idx="389">
                  <c:v>0.54545</c:v>
                </c:pt>
                <c:pt idx="390">
                  <c:v>0.54713</c:v>
                </c:pt>
                <c:pt idx="391">
                  <c:v>0.55283</c:v>
                </c:pt>
                <c:pt idx="392">
                  <c:v>0.55432</c:v>
                </c:pt>
                <c:pt idx="393">
                  <c:v>0.55501</c:v>
                </c:pt>
                <c:pt idx="394">
                  <c:v>0.55822</c:v>
                </c:pt>
                <c:pt idx="395">
                  <c:v>0.56311</c:v>
                </c:pt>
                <c:pt idx="396">
                  <c:v>0.56694</c:v>
                </c:pt>
                <c:pt idx="397">
                  <c:v>0.57947</c:v>
                </c:pt>
                <c:pt idx="398">
                  <c:v>0.58160237388724</c:v>
                </c:pt>
                <c:pt idx="399">
                  <c:v>0.58199</c:v>
                </c:pt>
                <c:pt idx="400">
                  <c:v>0.58934</c:v>
                </c:pt>
                <c:pt idx="401">
                  <c:v>0.5919</c:v>
                </c:pt>
                <c:pt idx="402">
                  <c:v>0.59528</c:v>
                </c:pt>
                <c:pt idx="403">
                  <c:v>0.5974</c:v>
                </c:pt>
                <c:pt idx="404">
                  <c:v>0.60385</c:v>
                </c:pt>
                <c:pt idx="405">
                  <c:v>0.61338</c:v>
                </c:pt>
                <c:pt idx="406">
                  <c:v>0.62037</c:v>
                </c:pt>
                <c:pt idx="407">
                  <c:v>0.6231</c:v>
                </c:pt>
                <c:pt idx="408">
                  <c:v>0.62473</c:v>
                </c:pt>
                <c:pt idx="409">
                  <c:v>0.63719</c:v>
                </c:pt>
                <c:pt idx="410">
                  <c:v>0.64671</c:v>
                </c:pt>
                <c:pt idx="411">
                  <c:v>0.64796</c:v>
                </c:pt>
                <c:pt idx="412">
                  <c:v>0.65421</c:v>
                </c:pt>
                <c:pt idx="413">
                  <c:v>0.65983</c:v>
                </c:pt>
                <c:pt idx="414">
                  <c:v>0.66187</c:v>
                </c:pt>
                <c:pt idx="415">
                  <c:v>0.67539</c:v>
                </c:pt>
                <c:pt idx="416">
                  <c:v>0.67671</c:v>
                </c:pt>
                <c:pt idx="417">
                  <c:v>0.67705</c:v>
                </c:pt>
                <c:pt idx="418">
                  <c:v>0.67828</c:v>
                </c:pt>
                <c:pt idx="419">
                  <c:v>0.7003</c:v>
                </c:pt>
                <c:pt idx="420">
                  <c:v>0.7094</c:v>
                </c:pt>
                <c:pt idx="421">
                  <c:v>0.72362</c:v>
                </c:pt>
                <c:pt idx="422">
                  <c:v>0.73115</c:v>
                </c:pt>
                <c:pt idx="423">
                  <c:v>0.73649</c:v>
                </c:pt>
                <c:pt idx="424">
                  <c:v>0.73874</c:v>
                </c:pt>
                <c:pt idx="425">
                  <c:v>0.74257</c:v>
                </c:pt>
                <c:pt idx="426">
                  <c:v>0.74429</c:v>
                </c:pt>
                <c:pt idx="427">
                  <c:v>0.75335</c:v>
                </c:pt>
                <c:pt idx="428">
                  <c:v>0.77228</c:v>
                </c:pt>
                <c:pt idx="429">
                  <c:v>0.77762</c:v>
                </c:pt>
                <c:pt idx="430">
                  <c:v>0.79974</c:v>
                </c:pt>
                <c:pt idx="431">
                  <c:v>0.82533</c:v>
                </c:pt>
                <c:pt idx="432">
                  <c:v>0.86366</c:v>
                </c:pt>
                <c:pt idx="433">
                  <c:v>0.8961</c:v>
                </c:pt>
              </c:numCache>
            </c:numRef>
          </c:yVal>
          <c:smooth val="0"/>
        </c:ser>
        <c:ser>
          <c:idx val="2"/>
          <c:order val="2"/>
          <c:tx>
            <c:v>Private to metastasis</c:v>
          </c:tx>
          <c:spPr>
            <a:ln w="47625">
              <a:noFill/>
            </a:ln>
          </c:spPr>
          <c:marker>
            <c:symbol val="circle"/>
            <c:size val="6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2"/>
                </a:solidFill>
              </a:ln>
            </c:spPr>
          </c:marker>
          <c:xVal>
            <c:numRef>
              <c:f>Sheet1!$C$2:$C$435</c:f>
              <c:numCache>
                <c:formatCode>General</c:formatCode>
                <c:ptCount val="434"/>
                <c:pt idx="0">
                  <c:v>0.04141</c:v>
                </c:pt>
                <c:pt idx="1">
                  <c:v>0.05051</c:v>
                </c:pt>
                <c:pt idx="2">
                  <c:v>0.05164</c:v>
                </c:pt>
                <c:pt idx="3">
                  <c:v>0.05347</c:v>
                </c:pt>
                <c:pt idx="4">
                  <c:v>0.05373</c:v>
                </c:pt>
                <c:pt idx="5">
                  <c:v>0.05946</c:v>
                </c:pt>
                <c:pt idx="6">
                  <c:v>0.06163</c:v>
                </c:pt>
                <c:pt idx="7">
                  <c:v>0.06203</c:v>
                </c:pt>
                <c:pt idx="8">
                  <c:v>0.07507</c:v>
                </c:pt>
                <c:pt idx="9">
                  <c:v>0.08626</c:v>
                </c:pt>
                <c:pt idx="10">
                  <c:v>0.08629</c:v>
                </c:pt>
                <c:pt idx="11">
                  <c:v>0.08706</c:v>
                </c:pt>
                <c:pt idx="12">
                  <c:v>0.09113</c:v>
                </c:pt>
                <c:pt idx="13">
                  <c:v>0.09412</c:v>
                </c:pt>
                <c:pt idx="14">
                  <c:v>0.09496</c:v>
                </c:pt>
                <c:pt idx="15">
                  <c:v>0.12346</c:v>
                </c:pt>
                <c:pt idx="16">
                  <c:v>0.1345</c:v>
                </c:pt>
                <c:pt idx="17">
                  <c:v>0.17078</c:v>
                </c:pt>
                <c:pt idx="18">
                  <c:v>0.18056</c:v>
                </c:pt>
                <c:pt idx="19">
                  <c:v>0.18542</c:v>
                </c:pt>
                <c:pt idx="20">
                  <c:v>0.18644</c:v>
                </c:pt>
                <c:pt idx="21">
                  <c:v>0.215</c:v>
                </c:pt>
                <c:pt idx="22">
                  <c:v>0.21883</c:v>
                </c:pt>
                <c:pt idx="23">
                  <c:v>0.28336</c:v>
                </c:pt>
                <c:pt idx="24">
                  <c:v>0.28794</c:v>
                </c:pt>
                <c:pt idx="25">
                  <c:v>0.28814</c:v>
                </c:pt>
                <c:pt idx="26">
                  <c:v>0.29331</c:v>
                </c:pt>
                <c:pt idx="27">
                  <c:v>0.31429</c:v>
                </c:pt>
                <c:pt idx="28">
                  <c:v>0.35994</c:v>
                </c:pt>
                <c:pt idx="29">
                  <c:v>0.4376</c:v>
                </c:pt>
                <c:pt idx="30">
                  <c:v>0.53008</c:v>
                </c:pt>
                <c:pt idx="31">
                  <c:v>0.55236</c:v>
                </c:pt>
                <c:pt idx="32">
                  <c:v>0.27101</c:v>
                </c:pt>
                <c:pt idx="33">
                  <c:v>0.07298</c:v>
                </c:pt>
                <c:pt idx="34">
                  <c:v>0.12541</c:v>
                </c:pt>
                <c:pt idx="35">
                  <c:v>0.09327</c:v>
                </c:pt>
                <c:pt idx="36">
                  <c:v>0.12667</c:v>
                </c:pt>
                <c:pt idx="37">
                  <c:v>0.13084</c:v>
                </c:pt>
                <c:pt idx="38">
                  <c:v>0.19682</c:v>
                </c:pt>
                <c:pt idx="39">
                  <c:v>0.20497</c:v>
                </c:pt>
                <c:pt idx="40">
                  <c:v>0.053</c:v>
                </c:pt>
                <c:pt idx="41">
                  <c:v>0.14082</c:v>
                </c:pt>
                <c:pt idx="42">
                  <c:v>0.19668</c:v>
                </c:pt>
                <c:pt idx="43">
                  <c:v>0.14019</c:v>
                </c:pt>
                <c:pt idx="44">
                  <c:v>0.27094</c:v>
                </c:pt>
                <c:pt idx="45">
                  <c:v>0.23973</c:v>
                </c:pt>
                <c:pt idx="46">
                  <c:v>0.1994</c:v>
                </c:pt>
                <c:pt idx="47">
                  <c:v>0.2381</c:v>
                </c:pt>
                <c:pt idx="48">
                  <c:v>0.12247</c:v>
                </c:pt>
                <c:pt idx="49">
                  <c:v>0.13418</c:v>
                </c:pt>
                <c:pt idx="50">
                  <c:v>0.16616</c:v>
                </c:pt>
                <c:pt idx="51">
                  <c:v>0.21053</c:v>
                </c:pt>
                <c:pt idx="52">
                  <c:v>0.20134</c:v>
                </c:pt>
                <c:pt idx="53">
                  <c:v>0.2043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7414</c:v>
                </c:pt>
                <c:pt idx="58">
                  <c:v>0.23709</c:v>
                </c:pt>
                <c:pt idx="59">
                  <c:v>0.0</c:v>
                </c:pt>
                <c:pt idx="60">
                  <c:v>0.02391</c:v>
                </c:pt>
                <c:pt idx="61">
                  <c:v>0.1657</c:v>
                </c:pt>
                <c:pt idx="62">
                  <c:v>0.14444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30986</c:v>
                </c:pt>
                <c:pt idx="69">
                  <c:v>0.38723</c:v>
                </c:pt>
                <c:pt idx="70">
                  <c:v>0.08459</c:v>
                </c:pt>
                <c:pt idx="71">
                  <c:v>0.00249</c:v>
                </c:pt>
                <c:pt idx="72">
                  <c:v>0.10238</c:v>
                </c:pt>
                <c:pt idx="73">
                  <c:v>0.29637</c:v>
                </c:pt>
                <c:pt idx="74">
                  <c:v>0.41535</c:v>
                </c:pt>
                <c:pt idx="75">
                  <c:v>0.15916</c:v>
                </c:pt>
                <c:pt idx="76">
                  <c:v>0.10013</c:v>
                </c:pt>
                <c:pt idx="77">
                  <c:v>0.00151</c:v>
                </c:pt>
                <c:pt idx="78">
                  <c:v>0.0</c:v>
                </c:pt>
                <c:pt idx="79">
                  <c:v>0.14105</c:v>
                </c:pt>
                <c:pt idx="80">
                  <c:v>0.13049</c:v>
                </c:pt>
                <c:pt idx="81">
                  <c:v>0.20021</c:v>
                </c:pt>
                <c:pt idx="82">
                  <c:v>0.34278</c:v>
                </c:pt>
                <c:pt idx="83">
                  <c:v>0.0</c:v>
                </c:pt>
                <c:pt idx="84">
                  <c:v>0.40599</c:v>
                </c:pt>
                <c:pt idx="85">
                  <c:v>0.10246</c:v>
                </c:pt>
                <c:pt idx="86">
                  <c:v>0.22075</c:v>
                </c:pt>
                <c:pt idx="87">
                  <c:v>0.11872</c:v>
                </c:pt>
                <c:pt idx="88">
                  <c:v>0.0494</c:v>
                </c:pt>
                <c:pt idx="89">
                  <c:v>0.16172</c:v>
                </c:pt>
                <c:pt idx="90">
                  <c:v>0.33333</c:v>
                </c:pt>
                <c:pt idx="91">
                  <c:v>0.409</c:v>
                </c:pt>
                <c:pt idx="92">
                  <c:v>0.0</c:v>
                </c:pt>
                <c:pt idx="93">
                  <c:v>0.13622</c:v>
                </c:pt>
                <c:pt idx="94">
                  <c:v>0.40923</c:v>
                </c:pt>
                <c:pt idx="95">
                  <c:v>0.12247</c:v>
                </c:pt>
                <c:pt idx="96">
                  <c:v>0.0</c:v>
                </c:pt>
                <c:pt idx="97">
                  <c:v>0.19159</c:v>
                </c:pt>
                <c:pt idx="98">
                  <c:v>0.09418</c:v>
                </c:pt>
                <c:pt idx="99">
                  <c:v>0.14286</c:v>
                </c:pt>
                <c:pt idx="100">
                  <c:v>0.14956</c:v>
                </c:pt>
                <c:pt idx="101">
                  <c:v>0.27215</c:v>
                </c:pt>
                <c:pt idx="102">
                  <c:v>0.0</c:v>
                </c:pt>
                <c:pt idx="103">
                  <c:v>0.05466</c:v>
                </c:pt>
                <c:pt idx="104">
                  <c:v>0.07952</c:v>
                </c:pt>
                <c:pt idx="105">
                  <c:v>0.28313</c:v>
                </c:pt>
                <c:pt idx="106">
                  <c:v>0.28883</c:v>
                </c:pt>
                <c:pt idx="107">
                  <c:v>0.09948</c:v>
                </c:pt>
                <c:pt idx="108">
                  <c:v>0.0</c:v>
                </c:pt>
                <c:pt idx="109">
                  <c:v>0.25509</c:v>
                </c:pt>
                <c:pt idx="110">
                  <c:v>0.17355</c:v>
                </c:pt>
                <c:pt idx="111">
                  <c:v>0.0</c:v>
                </c:pt>
                <c:pt idx="112">
                  <c:v>0.4359</c:v>
                </c:pt>
                <c:pt idx="113">
                  <c:v>0.00328</c:v>
                </c:pt>
                <c:pt idx="114">
                  <c:v>0.17115</c:v>
                </c:pt>
                <c:pt idx="115">
                  <c:v>0.11296</c:v>
                </c:pt>
                <c:pt idx="116">
                  <c:v>0.1223</c:v>
                </c:pt>
                <c:pt idx="117">
                  <c:v>0.12906</c:v>
                </c:pt>
                <c:pt idx="118">
                  <c:v>0.29265</c:v>
                </c:pt>
                <c:pt idx="119">
                  <c:v>0.28077</c:v>
                </c:pt>
                <c:pt idx="120">
                  <c:v>0.20598</c:v>
                </c:pt>
                <c:pt idx="121">
                  <c:v>0.0</c:v>
                </c:pt>
                <c:pt idx="122">
                  <c:v>0.0</c:v>
                </c:pt>
                <c:pt idx="123">
                  <c:v>0.46667</c:v>
                </c:pt>
                <c:pt idx="124">
                  <c:v>0.15328</c:v>
                </c:pt>
                <c:pt idx="125">
                  <c:v>0.11158</c:v>
                </c:pt>
                <c:pt idx="126">
                  <c:v>0.12039</c:v>
                </c:pt>
                <c:pt idx="127">
                  <c:v>0.23007</c:v>
                </c:pt>
                <c:pt idx="128">
                  <c:v>0.48764</c:v>
                </c:pt>
                <c:pt idx="129">
                  <c:v>0.22486</c:v>
                </c:pt>
                <c:pt idx="130">
                  <c:v>0.28438</c:v>
                </c:pt>
                <c:pt idx="131">
                  <c:v>0.21073</c:v>
                </c:pt>
                <c:pt idx="132">
                  <c:v>0.21654</c:v>
                </c:pt>
                <c:pt idx="133">
                  <c:v>0.23408</c:v>
                </c:pt>
                <c:pt idx="134">
                  <c:v>0.23087</c:v>
                </c:pt>
                <c:pt idx="135">
                  <c:v>0.24041</c:v>
                </c:pt>
                <c:pt idx="136">
                  <c:v>0.11605</c:v>
                </c:pt>
                <c:pt idx="137">
                  <c:v>0.18878</c:v>
                </c:pt>
                <c:pt idx="138">
                  <c:v>0.17411</c:v>
                </c:pt>
                <c:pt idx="139">
                  <c:v>0.00301</c:v>
                </c:pt>
                <c:pt idx="140">
                  <c:v>0.27451</c:v>
                </c:pt>
                <c:pt idx="141">
                  <c:v>0.0</c:v>
                </c:pt>
                <c:pt idx="142">
                  <c:v>0.06383</c:v>
                </c:pt>
                <c:pt idx="143">
                  <c:v>0.18513</c:v>
                </c:pt>
                <c:pt idx="144">
                  <c:v>0.1189</c:v>
                </c:pt>
                <c:pt idx="145">
                  <c:v>0.0</c:v>
                </c:pt>
                <c:pt idx="146">
                  <c:v>0.21965</c:v>
                </c:pt>
                <c:pt idx="147">
                  <c:v>0.16667</c:v>
                </c:pt>
                <c:pt idx="148">
                  <c:v>0.16667</c:v>
                </c:pt>
                <c:pt idx="149">
                  <c:v>0.06691</c:v>
                </c:pt>
                <c:pt idx="150">
                  <c:v>0.12476</c:v>
                </c:pt>
                <c:pt idx="151">
                  <c:v>0.24078</c:v>
                </c:pt>
                <c:pt idx="152">
                  <c:v>0.36126</c:v>
                </c:pt>
                <c:pt idx="153">
                  <c:v>0.0</c:v>
                </c:pt>
                <c:pt idx="154">
                  <c:v>0.16722</c:v>
                </c:pt>
                <c:pt idx="155">
                  <c:v>0.02703</c:v>
                </c:pt>
                <c:pt idx="156">
                  <c:v>0.22865</c:v>
                </c:pt>
                <c:pt idx="157">
                  <c:v>0.30488</c:v>
                </c:pt>
                <c:pt idx="158">
                  <c:v>0.29044</c:v>
                </c:pt>
                <c:pt idx="159">
                  <c:v>0.0</c:v>
                </c:pt>
                <c:pt idx="160">
                  <c:v>0.1318</c:v>
                </c:pt>
                <c:pt idx="161">
                  <c:v>0.30472</c:v>
                </c:pt>
                <c:pt idx="162">
                  <c:v>0.03972</c:v>
                </c:pt>
                <c:pt idx="163">
                  <c:v>0.11491</c:v>
                </c:pt>
                <c:pt idx="164">
                  <c:v>0.15841</c:v>
                </c:pt>
                <c:pt idx="165">
                  <c:v>0.16253</c:v>
                </c:pt>
                <c:pt idx="166">
                  <c:v>0.0</c:v>
                </c:pt>
                <c:pt idx="167">
                  <c:v>0.33896</c:v>
                </c:pt>
                <c:pt idx="168">
                  <c:v>0.18218</c:v>
                </c:pt>
                <c:pt idx="169">
                  <c:v>0.22241</c:v>
                </c:pt>
                <c:pt idx="170">
                  <c:v>0.27441</c:v>
                </c:pt>
                <c:pt idx="171">
                  <c:v>0.0</c:v>
                </c:pt>
                <c:pt idx="172">
                  <c:v>0.19024</c:v>
                </c:pt>
                <c:pt idx="173">
                  <c:v>0.21888</c:v>
                </c:pt>
                <c:pt idx="174">
                  <c:v>0.11051</c:v>
                </c:pt>
                <c:pt idx="175">
                  <c:v>0.20493</c:v>
                </c:pt>
                <c:pt idx="176">
                  <c:v>0.21429</c:v>
                </c:pt>
                <c:pt idx="177">
                  <c:v>0.09677</c:v>
                </c:pt>
                <c:pt idx="178">
                  <c:v>0.05743</c:v>
                </c:pt>
                <c:pt idx="179">
                  <c:v>0.2577</c:v>
                </c:pt>
                <c:pt idx="180">
                  <c:v>0.08462</c:v>
                </c:pt>
                <c:pt idx="181">
                  <c:v>0.21629</c:v>
                </c:pt>
                <c:pt idx="182">
                  <c:v>0.20524</c:v>
                </c:pt>
                <c:pt idx="183">
                  <c:v>0.0</c:v>
                </c:pt>
                <c:pt idx="184">
                  <c:v>0.05977</c:v>
                </c:pt>
                <c:pt idx="185">
                  <c:v>0.18047</c:v>
                </c:pt>
                <c:pt idx="186">
                  <c:v>0.12136</c:v>
                </c:pt>
                <c:pt idx="187">
                  <c:v>0.1274</c:v>
                </c:pt>
                <c:pt idx="188">
                  <c:v>0.29027</c:v>
                </c:pt>
                <c:pt idx="189">
                  <c:v>0.21145</c:v>
                </c:pt>
                <c:pt idx="190">
                  <c:v>0.22555</c:v>
                </c:pt>
                <c:pt idx="191">
                  <c:v>0.30576</c:v>
                </c:pt>
                <c:pt idx="192">
                  <c:v>0.2082</c:v>
                </c:pt>
                <c:pt idx="193">
                  <c:v>0.12708</c:v>
                </c:pt>
                <c:pt idx="194">
                  <c:v>0.26092</c:v>
                </c:pt>
                <c:pt idx="195">
                  <c:v>0.24804</c:v>
                </c:pt>
                <c:pt idx="196">
                  <c:v>0.18685</c:v>
                </c:pt>
                <c:pt idx="197">
                  <c:v>0.35698</c:v>
                </c:pt>
                <c:pt idx="198">
                  <c:v>0.20513</c:v>
                </c:pt>
                <c:pt idx="199">
                  <c:v>0.20351</c:v>
                </c:pt>
                <c:pt idx="200">
                  <c:v>0.23617</c:v>
                </c:pt>
                <c:pt idx="201">
                  <c:v>0.16236</c:v>
                </c:pt>
                <c:pt idx="202">
                  <c:v>0.2226</c:v>
                </c:pt>
                <c:pt idx="203">
                  <c:v>0.246575342465753</c:v>
                </c:pt>
                <c:pt idx="204">
                  <c:v>0.27477</c:v>
                </c:pt>
                <c:pt idx="205">
                  <c:v>0.23016</c:v>
                </c:pt>
                <c:pt idx="206">
                  <c:v>0.26837</c:v>
                </c:pt>
                <c:pt idx="207">
                  <c:v>0.28442</c:v>
                </c:pt>
                <c:pt idx="208">
                  <c:v>0.29156</c:v>
                </c:pt>
                <c:pt idx="209">
                  <c:v>0.0</c:v>
                </c:pt>
                <c:pt idx="210">
                  <c:v>0.2877</c:v>
                </c:pt>
                <c:pt idx="211">
                  <c:v>0.27072</c:v>
                </c:pt>
                <c:pt idx="212">
                  <c:v>0.49143</c:v>
                </c:pt>
                <c:pt idx="213">
                  <c:v>0.13759</c:v>
                </c:pt>
                <c:pt idx="214">
                  <c:v>0.15933</c:v>
                </c:pt>
                <c:pt idx="215">
                  <c:v>0.11253</c:v>
                </c:pt>
                <c:pt idx="216">
                  <c:v>0.19693</c:v>
                </c:pt>
                <c:pt idx="217">
                  <c:v>0.19281</c:v>
                </c:pt>
                <c:pt idx="218">
                  <c:v>0.25473</c:v>
                </c:pt>
                <c:pt idx="219">
                  <c:v>0.25087</c:v>
                </c:pt>
                <c:pt idx="220">
                  <c:v>0.08108</c:v>
                </c:pt>
                <c:pt idx="221">
                  <c:v>0.23103</c:v>
                </c:pt>
                <c:pt idx="222">
                  <c:v>0.32296</c:v>
                </c:pt>
                <c:pt idx="223">
                  <c:v>0.15725</c:v>
                </c:pt>
                <c:pt idx="224">
                  <c:v>0.32133</c:v>
                </c:pt>
                <c:pt idx="225">
                  <c:v>0.14858</c:v>
                </c:pt>
                <c:pt idx="226">
                  <c:v>0.29429</c:v>
                </c:pt>
                <c:pt idx="227">
                  <c:v>0.13098</c:v>
                </c:pt>
                <c:pt idx="228">
                  <c:v>0.0914</c:v>
                </c:pt>
                <c:pt idx="229">
                  <c:v>0.34413</c:v>
                </c:pt>
                <c:pt idx="230">
                  <c:v>0.25894</c:v>
                </c:pt>
                <c:pt idx="231">
                  <c:v>0.24049</c:v>
                </c:pt>
                <c:pt idx="232">
                  <c:v>0.23077</c:v>
                </c:pt>
                <c:pt idx="233">
                  <c:v>0.01991</c:v>
                </c:pt>
                <c:pt idx="234">
                  <c:v>0.3902</c:v>
                </c:pt>
                <c:pt idx="235">
                  <c:v>0.0</c:v>
                </c:pt>
                <c:pt idx="236">
                  <c:v>0.0</c:v>
                </c:pt>
                <c:pt idx="237">
                  <c:v>0.13456</c:v>
                </c:pt>
                <c:pt idx="238">
                  <c:v>0.07864</c:v>
                </c:pt>
                <c:pt idx="239">
                  <c:v>0.26686</c:v>
                </c:pt>
                <c:pt idx="240">
                  <c:v>0.41379</c:v>
                </c:pt>
                <c:pt idx="241">
                  <c:v>0.13619</c:v>
                </c:pt>
                <c:pt idx="242">
                  <c:v>0.0</c:v>
                </c:pt>
                <c:pt idx="243">
                  <c:v>0.31637</c:v>
                </c:pt>
                <c:pt idx="244">
                  <c:v>0.29752</c:v>
                </c:pt>
                <c:pt idx="245">
                  <c:v>0.27273</c:v>
                </c:pt>
                <c:pt idx="246">
                  <c:v>0.24194</c:v>
                </c:pt>
                <c:pt idx="247">
                  <c:v>0.31991</c:v>
                </c:pt>
                <c:pt idx="248">
                  <c:v>0.24784</c:v>
                </c:pt>
                <c:pt idx="249">
                  <c:v>0.30508</c:v>
                </c:pt>
                <c:pt idx="250">
                  <c:v>0.25908</c:v>
                </c:pt>
                <c:pt idx="251">
                  <c:v>0.13628</c:v>
                </c:pt>
                <c:pt idx="252">
                  <c:v>0.20635</c:v>
                </c:pt>
                <c:pt idx="253">
                  <c:v>0.59091</c:v>
                </c:pt>
                <c:pt idx="254">
                  <c:v>0.27896</c:v>
                </c:pt>
                <c:pt idx="255">
                  <c:v>0.1269</c:v>
                </c:pt>
                <c:pt idx="256">
                  <c:v>0.33009</c:v>
                </c:pt>
                <c:pt idx="257">
                  <c:v>0.21472</c:v>
                </c:pt>
                <c:pt idx="258">
                  <c:v>0.10996</c:v>
                </c:pt>
                <c:pt idx="259">
                  <c:v>0.28297</c:v>
                </c:pt>
                <c:pt idx="260">
                  <c:v>0.05875</c:v>
                </c:pt>
                <c:pt idx="261">
                  <c:v>0.13709</c:v>
                </c:pt>
                <c:pt idx="262">
                  <c:v>0.34921</c:v>
                </c:pt>
                <c:pt idx="263">
                  <c:v>0.27286</c:v>
                </c:pt>
                <c:pt idx="264">
                  <c:v>0.26667</c:v>
                </c:pt>
                <c:pt idx="265">
                  <c:v>0.0219</c:v>
                </c:pt>
                <c:pt idx="266">
                  <c:v>0.24901</c:v>
                </c:pt>
                <c:pt idx="267">
                  <c:v>0.45316</c:v>
                </c:pt>
                <c:pt idx="268">
                  <c:v>0.43716577540107</c:v>
                </c:pt>
                <c:pt idx="269">
                  <c:v>0.37947</c:v>
                </c:pt>
                <c:pt idx="270">
                  <c:v>0.52077</c:v>
                </c:pt>
                <c:pt idx="271">
                  <c:v>0.32542</c:v>
                </c:pt>
                <c:pt idx="272">
                  <c:v>0.125</c:v>
                </c:pt>
                <c:pt idx="273">
                  <c:v>0.35762</c:v>
                </c:pt>
                <c:pt idx="274">
                  <c:v>0.26087</c:v>
                </c:pt>
                <c:pt idx="275">
                  <c:v>0.2437</c:v>
                </c:pt>
                <c:pt idx="276">
                  <c:v>0.30392</c:v>
                </c:pt>
                <c:pt idx="277">
                  <c:v>0.33471</c:v>
                </c:pt>
                <c:pt idx="278">
                  <c:v>0.38619</c:v>
                </c:pt>
                <c:pt idx="279">
                  <c:v>0.32373</c:v>
                </c:pt>
                <c:pt idx="280">
                  <c:v>0.27273</c:v>
                </c:pt>
                <c:pt idx="281">
                  <c:v>0.35047</c:v>
                </c:pt>
                <c:pt idx="282">
                  <c:v>0.33989</c:v>
                </c:pt>
                <c:pt idx="283">
                  <c:v>0.28777</c:v>
                </c:pt>
                <c:pt idx="284">
                  <c:v>0.18956</c:v>
                </c:pt>
                <c:pt idx="285">
                  <c:v>0.29385</c:v>
                </c:pt>
                <c:pt idx="286">
                  <c:v>0.34585</c:v>
                </c:pt>
                <c:pt idx="287">
                  <c:v>0.25073</c:v>
                </c:pt>
                <c:pt idx="288">
                  <c:v>0.14785</c:v>
                </c:pt>
                <c:pt idx="289">
                  <c:v>0.34073</c:v>
                </c:pt>
                <c:pt idx="290">
                  <c:v>0.33653</c:v>
                </c:pt>
                <c:pt idx="291">
                  <c:v>0.38679</c:v>
                </c:pt>
                <c:pt idx="292">
                  <c:v>0.29825</c:v>
                </c:pt>
                <c:pt idx="293">
                  <c:v>0.23211</c:v>
                </c:pt>
                <c:pt idx="294">
                  <c:v>0.44661</c:v>
                </c:pt>
                <c:pt idx="295">
                  <c:v>0.14729</c:v>
                </c:pt>
                <c:pt idx="296">
                  <c:v>0.30028</c:v>
                </c:pt>
                <c:pt idx="297">
                  <c:v>0.15864</c:v>
                </c:pt>
                <c:pt idx="298">
                  <c:v>0.29244</c:v>
                </c:pt>
                <c:pt idx="299">
                  <c:v>0.6635</c:v>
                </c:pt>
                <c:pt idx="300">
                  <c:v>0.43013</c:v>
                </c:pt>
                <c:pt idx="301">
                  <c:v>0.28074</c:v>
                </c:pt>
                <c:pt idx="302">
                  <c:v>0.46006</c:v>
                </c:pt>
                <c:pt idx="303">
                  <c:v>0.1577</c:v>
                </c:pt>
                <c:pt idx="304">
                  <c:v>0.55122</c:v>
                </c:pt>
                <c:pt idx="305">
                  <c:v>0.0</c:v>
                </c:pt>
                <c:pt idx="306">
                  <c:v>0.42102</c:v>
                </c:pt>
                <c:pt idx="307">
                  <c:v>0.39539</c:v>
                </c:pt>
                <c:pt idx="308">
                  <c:v>0.39299</c:v>
                </c:pt>
                <c:pt idx="309">
                  <c:v>0.42621</c:v>
                </c:pt>
                <c:pt idx="310">
                  <c:v>0.31635</c:v>
                </c:pt>
                <c:pt idx="311">
                  <c:v>0.83493</c:v>
                </c:pt>
                <c:pt idx="312">
                  <c:v>0.3631</c:v>
                </c:pt>
                <c:pt idx="313">
                  <c:v>0.20192</c:v>
                </c:pt>
                <c:pt idx="314">
                  <c:v>0.0</c:v>
                </c:pt>
                <c:pt idx="315">
                  <c:v>0.22259</c:v>
                </c:pt>
                <c:pt idx="316">
                  <c:v>0.44112</c:v>
                </c:pt>
                <c:pt idx="317">
                  <c:v>0.72414</c:v>
                </c:pt>
                <c:pt idx="318">
                  <c:v>0.40398</c:v>
                </c:pt>
                <c:pt idx="319">
                  <c:v>0.40975</c:v>
                </c:pt>
                <c:pt idx="320">
                  <c:v>0.36571</c:v>
                </c:pt>
                <c:pt idx="321">
                  <c:v>0.47649</c:v>
                </c:pt>
                <c:pt idx="322">
                  <c:v>0.87319</c:v>
                </c:pt>
                <c:pt idx="323">
                  <c:v>0.35583</c:v>
                </c:pt>
                <c:pt idx="324">
                  <c:v>0.0</c:v>
                </c:pt>
                <c:pt idx="325">
                  <c:v>0.14532</c:v>
                </c:pt>
                <c:pt idx="326">
                  <c:v>0.16129</c:v>
                </c:pt>
                <c:pt idx="327">
                  <c:v>0.33529</c:v>
                </c:pt>
                <c:pt idx="328">
                  <c:v>0.23504</c:v>
                </c:pt>
                <c:pt idx="329">
                  <c:v>0.00147</c:v>
                </c:pt>
                <c:pt idx="330">
                  <c:v>0.25225</c:v>
                </c:pt>
                <c:pt idx="331">
                  <c:v>0.24123</c:v>
                </c:pt>
                <c:pt idx="332">
                  <c:v>0.22222</c:v>
                </c:pt>
                <c:pt idx="333">
                  <c:v>0.12609</c:v>
                </c:pt>
                <c:pt idx="334">
                  <c:v>0.22357</c:v>
                </c:pt>
                <c:pt idx="335">
                  <c:v>0.41331</c:v>
                </c:pt>
                <c:pt idx="336">
                  <c:v>0.00387</c:v>
                </c:pt>
                <c:pt idx="337">
                  <c:v>0.30457</c:v>
                </c:pt>
                <c:pt idx="338">
                  <c:v>0.36861</c:v>
                </c:pt>
                <c:pt idx="339">
                  <c:v>0.46436</c:v>
                </c:pt>
                <c:pt idx="340">
                  <c:v>0.17311</c:v>
                </c:pt>
                <c:pt idx="341">
                  <c:v>0.22622</c:v>
                </c:pt>
                <c:pt idx="342">
                  <c:v>0.36691</c:v>
                </c:pt>
                <c:pt idx="343">
                  <c:v>0.15334</c:v>
                </c:pt>
                <c:pt idx="344">
                  <c:v>0.25591</c:v>
                </c:pt>
                <c:pt idx="345">
                  <c:v>0.14439</c:v>
                </c:pt>
                <c:pt idx="346">
                  <c:v>0.41579</c:v>
                </c:pt>
                <c:pt idx="347">
                  <c:v>0.47425</c:v>
                </c:pt>
                <c:pt idx="348">
                  <c:v>0.37716</c:v>
                </c:pt>
                <c:pt idx="349">
                  <c:v>0.43177</c:v>
                </c:pt>
                <c:pt idx="350">
                  <c:v>0.41364</c:v>
                </c:pt>
                <c:pt idx="351">
                  <c:v>0.32361</c:v>
                </c:pt>
                <c:pt idx="352">
                  <c:v>0.3425</c:v>
                </c:pt>
                <c:pt idx="353">
                  <c:v>0.40405</c:v>
                </c:pt>
                <c:pt idx="354">
                  <c:v>0.27778</c:v>
                </c:pt>
                <c:pt idx="355">
                  <c:v>0.42857</c:v>
                </c:pt>
                <c:pt idx="356">
                  <c:v>0.62195</c:v>
                </c:pt>
                <c:pt idx="357">
                  <c:v>0.39359</c:v>
                </c:pt>
                <c:pt idx="358">
                  <c:v>0.19551</c:v>
                </c:pt>
                <c:pt idx="359">
                  <c:v>0.39931</c:v>
                </c:pt>
                <c:pt idx="360">
                  <c:v>0.41321</c:v>
                </c:pt>
                <c:pt idx="361">
                  <c:v>0.63709</c:v>
                </c:pt>
                <c:pt idx="362">
                  <c:v>0.34936</c:v>
                </c:pt>
                <c:pt idx="363">
                  <c:v>0.31907</c:v>
                </c:pt>
                <c:pt idx="364">
                  <c:v>0.83945</c:v>
                </c:pt>
                <c:pt idx="365">
                  <c:v>0.46</c:v>
                </c:pt>
                <c:pt idx="366">
                  <c:v>0.52975</c:v>
                </c:pt>
                <c:pt idx="367">
                  <c:v>0.5625</c:v>
                </c:pt>
                <c:pt idx="368">
                  <c:v>0.33485</c:v>
                </c:pt>
                <c:pt idx="369">
                  <c:v>0.14094</c:v>
                </c:pt>
                <c:pt idx="370">
                  <c:v>0.32646</c:v>
                </c:pt>
                <c:pt idx="371">
                  <c:v>0.34956</c:v>
                </c:pt>
                <c:pt idx="372">
                  <c:v>0.47739</c:v>
                </c:pt>
                <c:pt idx="373">
                  <c:v>0.34633</c:v>
                </c:pt>
                <c:pt idx="374">
                  <c:v>0.10084</c:v>
                </c:pt>
                <c:pt idx="375">
                  <c:v>0.44737</c:v>
                </c:pt>
                <c:pt idx="376">
                  <c:v>0.40892</c:v>
                </c:pt>
                <c:pt idx="377">
                  <c:v>0.44098</c:v>
                </c:pt>
                <c:pt idx="378">
                  <c:v>0.57179</c:v>
                </c:pt>
                <c:pt idx="379">
                  <c:v>0.38402</c:v>
                </c:pt>
                <c:pt idx="380">
                  <c:v>0.50563</c:v>
                </c:pt>
                <c:pt idx="381">
                  <c:v>0.57466</c:v>
                </c:pt>
                <c:pt idx="382">
                  <c:v>0.6145</c:v>
                </c:pt>
                <c:pt idx="383">
                  <c:v>0.28632</c:v>
                </c:pt>
                <c:pt idx="384">
                  <c:v>0.56707</c:v>
                </c:pt>
                <c:pt idx="385">
                  <c:v>0.33579</c:v>
                </c:pt>
                <c:pt idx="386">
                  <c:v>0.53483</c:v>
                </c:pt>
                <c:pt idx="387">
                  <c:v>0.15433</c:v>
                </c:pt>
                <c:pt idx="388">
                  <c:v>0.4523</c:v>
                </c:pt>
                <c:pt idx="389">
                  <c:v>0.27806</c:v>
                </c:pt>
                <c:pt idx="390">
                  <c:v>0.61327</c:v>
                </c:pt>
                <c:pt idx="391">
                  <c:v>0.17976</c:v>
                </c:pt>
                <c:pt idx="392">
                  <c:v>0.31165</c:v>
                </c:pt>
                <c:pt idx="393">
                  <c:v>0.46009</c:v>
                </c:pt>
                <c:pt idx="394">
                  <c:v>0.0</c:v>
                </c:pt>
                <c:pt idx="395">
                  <c:v>0.49438</c:v>
                </c:pt>
                <c:pt idx="396">
                  <c:v>0.61958</c:v>
                </c:pt>
                <c:pt idx="397">
                  <c:v>0.40441</c:v>
                </c:pt>
                <c:pt idx="398">
                  <c:v>0.237037037037037</c:v>
                </c:pt>
                <c:pt idx="399">
                  <c:v>0.67582</c:v>
                </c:pt>
                <c:pt idx="400">
                  <c:v>0.32013</c:v>
                </c:pt>
                <c:pt idx="401">
                  <c:v>0.51228</c:v>
                </c:pt>
                <c:pt idx="402">
                  <c:v>0.64068</c:v>
                </c:pt>
                <c:pt idx="403">
                  <c:v>0.34848</c:v>
                </c:pt>
                <c:pt idx="404">
                  <c:v>0.30058</c:v>
                </c:pt>
                <c:pt idx="405">
                  <c:v>0.33206</c:v>
                </c:pt>
                <c:pt idx="406">
                  <c:v>0.70898</c:v>
                </c:pt>
                <c:pt idx="407">
                  <c:v>0.30149</c:v>
                </c:pt>
                <c:pt idx="408">
                  <c:v>0.84289</c:v>
                </c:pt>
                <c:pt idx="409">
                  <c:v>0.31458</c:v>
                </c:pt>
                <c:pt idx="410">
                  <c:v>0.3066</c:v>
                </c:pt>
                <c:pt idx="411">
                  <c:v>0.3365</c:v>
                </c:pt>
                <c:pt idx="412">
                  <c:v>0.12</c:v>
                </c:pt>
                <c:pt idx="413">
                  <c:v>0.47548</c:v>
                </c:pt>
                <c:pt idx="414">
                  <c:v>0.47781</c:v>
                </c:pt>
                <c:pt idx="415">
                  <c:v>0.45135</c:v>
                </c:pt>
                <c:pt idx="416">
                  <c:v>0.32466</c:v>
                </c:pt>
                <c:pt idx="417">
                  <c:v>0.64256</c:v>
                </c:pt>
                <c:pt idx="418">
                  <c:v>0.56116</c:v>
                </c:pt>
                <c:pt idx="419">
                  <c:v>0.74107</c:v>
                </c:pt>
                <c:pt idx="420">
                  <c:v>0.30921</c:v>
                </c:pt>
                <c:pt idx="421">
                  <c:v>0.2686</c:v>
                </c:pt>
                <c:pt idx="422">
                  <c:v>0.20426</c:v>
                </c:pt>
                <c:pt idx="423">
                  <c:v>0.62887</c:v>
                </c:pt>
                <c:pt idx="424">
                  <c:v>0.20267</c:v>
                </c:pt>
                <c:pt idx="425">
                  <c:v>0.40031</c:v>
                </c:pt>
                <c:pt idx="426">
                  <c:v>0.52959</c:v>
                </c:pt>
                <c:pt idx="427">
                  <c:v>0.6375</c:v>
                </c:pt>
                <c:pt idx="428">
                  <c:v>0.64677</c:v>
                </c:pt>
                <c:pt idx="429">
                  <c:v>0.39327</c:v>
                </c:pt>
                <c:pt idx="430">
                  <c:v>0.41297</c:v>
                </c:pt>
                <c:pt idx="431">
                  <c:v>0.44208</c:v>
                </c:pt>
                <c:pt idx="432">
                  <c:v>0.81605</c:v>
                </c:pt>
                <c:pt idx="433">
                  <c:v>0.9181</c:v>
                </c:pt>
              </c:numCache>
            </c:numRef>
          </c:xVal>
          <c:yVal>
            <c:numRef>
              <c:f>Sheet1!$F$2:$F$435</c:f>
              <c:numCache>
                <c:formatCode>General</c:formatCode>
                <c:ptCount val="434"/>
                <c:pt idx="54">
                  <c:v>0.0515</c:v>
                </c:pt>
                <c:pt idx="55">
                  <c:v>0.05376</c:v>
                </c:pt>
                <c:pt idx="56">
                  <c:v>0.05443</c:v>
                </c:pt>
                <c:pt idx="59">
                  <c:v>0.05652</c:v>
                </c:pt>
                <c:pt idx="63">
                  <c:v>0.06271</c:v>
                </c:pt>
                <c:pt idx="64">
                  <c:v>0.06393</c:v>
                </c:pt>
                <c:pt idx="65">
                  <c:v>0.06442</c:v>
                </c:pt>
                <c:pt idx="66">
                  <c:v>0.06522</c:v>
                </c:pt>
                <c:pt idx="67">
                  <c:v>0.06731</c:v>
                </c:pt>
                <c:pt idx="71">
                  <c:v>0.07888</c:v>
                </c:pt>
                <c:pt idx="77">
                  <c:v>0.09016</c:v>
                </c:pt>
                <c:pt idx="78">
                  <c:v>0.09031</c:v>
                </c:pt>
                <c:pt idx="83">
                  <c:v>0.09496</c:v>
                </c:pt>
                <c:pt idx="92">
                  <c:v>0.10811</c:v>
                </c:pt>
                <c:pt idx="96">
                  <c:v>0.117</c:v>
                </c:pt>
                <c:pt idx="102">
                  <c:v>0.1246</c:v>
                </c:pt>
                <c:pt idx="108">
                  <c:v>0.13129</c:v>
                </c:pt>
                <c:pt idx="111">
                  <c:v>0.13408</c:v>
                </c:pt>
                <c:pt idx="113">
                  <c:v>0.13682</c:v>
                </c:pt>
                <c:pt idx="121">
                  <c:v>0.14599</c:v>
                </c:pt>
                <c:pt idx="122">
                  <c:v>0.14653</c:v>
                </c:pt>
                <c:pt idx="139">
                  <c:v>0.17226</c:v>
                </c:pt>
                <c:pt idx="141">
                  <c:v>0.17391</c:v>
                </c:pt>
                <c:pt idx="145">
                  <c:v>0.17797</c:v>
                </c:pt>
                <c:pt idx="153">
                  <c:v>0.18411</c:v>
                </c:pt>
                <c:pt idx="159">
                  <c:v>0.18739</c:v>
                </c:pt>
                <c:pt idx="166">
                  <c:v>0.19048</c:v>
                </c:pt>
                <c:pt idx="171">
                  <c:v>0.19512</c:v>
                </c:pt>
                <c:pt idx="183">
                  <c:v>0.20488</c:v>
                </c:pt>
                <c:pt idx="209">
                  <c:v>0.23223</c:v>
                </c:pt>
                <c:pt idx="235">
                  <c:v>0.26049</c:v>
                </c:pt>
                <c:pt idx="236">
                  <c:v>0.26068</c:v>
                </c:pt>
                <c:pt idx="242">
                  <c:v>0.26767</c:v>
                </c:pt>
                <c:pt idx="305">
                  <c:v>0.34945</c:v>
                </c:pt>
                <c:pt idx="314">
                  <c:v>0.36289</c:v>
                </c:pt>
                <c:pt idx="324">
                  <c:v>0.37193</c:v>
                </c:pt>
                <c:pt idx="329">
                  <c:v>0.37965</c:v>
                </c:pt>
                <c:pt idx="336">
                  <c:v>0.39227</c:v>
                </c:pt>
                <c:pt idx="394">
                  <c:v>0.5582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0558424"/>
        <c:axId val="2140555480"/>
      </c:scatterChart>
      <c:valAx>
        <c:axId val="2140558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Primary tumor allele frequen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40555480"/>
        <c:crosses val="autoZero"/>
        <c:crossBetween val="midCat"/>
      </c:valAx>
      <c:valAx>
        <c:axId val="2140555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Metastatic tumor allele frequen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40558424"/>
        <c:crosses val="autoZero"/>
        <c:crossBetween val="midCat"/>
      </c:valAx>
    </c:plotArea>
    <c:legend>
      <c:legendPos val="t"/>
      <c:layout/>
      <c:overlay val="1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6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862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1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62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05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6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897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41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5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5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26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206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41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6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3" y="364075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6" y="1913475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558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742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2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7EEC1-713B-4A45-96B0-580E5ECAB637}" type="datetimeFigureOut">
              <a:rPr lang="en-US" smtClean="0"/>
              <a:t>6/2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2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2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41A3C-72C4-194A-B567-F34B3F249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852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png"/><Relationship Id="rId10" Type="http://schemas.openxmlformats.org/officeDocument/2006/relationships/image" Target="../media/image17.png"/><Relationship Id="rId11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1099" y="105829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0033667"/>
              </p:ext>
            </p:extLst>
          </p:nvPr>
        </p:nvGraphicFramePr>
        <p:xfrm>
          <a:off x="141099" y="551276"/>
          <a:ext cx="6479114" cy="45974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23333" y="5317067"/>
            <a:ext cx="5994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The vast majority of alterations are shared between primary and metastatic tumors.  </a:t>
            </a:r>
            <a:r>
              <a:rPr lang="en-US" sz="1400" dirty="0" smtClean="0"/>
              <a:t>Of </a:t>
            </a:r>
            <a:r>
              <a:rPr lang="en-US" sz="1400" dirty="0"/>
              <a:t>the 434 total mutations, 344 (79%) were shared between patient-matched </a:t>
            </a:r>
            <a:r>
              <a:rPr lang="en-US" sz="1400" dirty="0" smtClean="0"/>
              <a:t>tumors (purple dots).  Mutations private to primary are in pink, and mutations private to metastasis are in blue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943019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760" y="5080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 </a:t>
            </a:r>
            <a:endParaRPr lang="en-US" dirty="0"/>
          </a:p>
        </p:txBody>
      </p:sp>
      <p:pic>
        <p:nvPicPr>
          <p:cNvPr id="7" name="Picture 6" descr="tp5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855" y="759979"/>
            <a:ext cx="3455922" cy="271693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3615" y="65687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9" name="Picture 8" descr="PIK3CA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854" y="3528885"/>
            <a:ext cx="5036873" cy="326244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35349" y="352888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23333" y="7078129"/>
            <a:ext cx="5994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nvergent evolution of genes was found in colon primary and metastatic tumors.  </a:t>
            </a:r>
            <a:r>
              <a:rPr lang="en-US" sz="1400" dirty="0" smtClean="0"/>
              <a:t>(A) Patient 38 has two different TP53 mutations: p.R248Q in the primary and p.Y163* in the metastasis. (B) Patient 7 has two hotspot mutations in PIK3CA: p.E542K in the primary and p.E545K in the metastasi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60991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760" y="5080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  <p:pic>
        <p:nvPicPr>
          <p:cNvPr id="44" name="Picture 43" descr="mek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83" y="576185"/>
            <a:ext cx="4311214" cy="318301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6183" y="4165580"/>
            <a:ext cx="599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atient 19 had a metastasis-specific activating mutation in MEK1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156250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760" y="5080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4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53119" y="3571164"/>
            <a:ext cx="5994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The MAP2K1 p.A106T mutation is not an activating mutation.</a:t>
            </a:r>
          </a:p>
          <a:p>
            <a:r>
              <a:rPr lang="en-US" sz="1400" dirty="0" smtClean="0"/>
              <a:t>MAP2K1 p.A106T GFP-tagged plasmids were transfected into 293H cells and behave as </a:t>
            </a:r>
            <a:r>
              <a:rPr lang="en-US" sz="1400" dirty="0" err="1" smtClean="0"/>
              <a:t>wildtype</a:t>
            </a:r>
            <a:r>
              <a:rPr lang="en-US" sz="1400" dirty="0" smtClean="0"/>
              <a:t> MAP2K1.</a:t>
            </a:r>
            <a:endParaRPr lang="en-US" sz="14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721582" y="660320"/>
            <a:ext cx="3562299" cy="2705565"/>
            <a:chOff x="2790851" y="3084395"/>
            <a:chExt cx="3562299" cy="2705565"/>
          </a:xfrm>
        </p:grpSpPr>
        <p:sp>
          <p:nvSpPr>
            <p:cNvPr id="15" name="TextBox 14"/>
            <p:cNvSpPr txBox="1"/>
            <p:nvPr/>
          </p:nvSpPr>
          <p:spPr>
            <a:xfrm>
              <a:off x="2916160" y="5574516"/>
              <a:ext cx="2035729" cy="2154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solidFill>
                    <a:srgbClr val="FF0000"/>
                  </a:solidFill>
                  <a:latin typeface="Arial"/>
                  <a:cs typeface="Arial"/>
                </a:rPr>
                <a:t>*</a:t>
              </a:r>
              <a:r>
                <a:rPr lang="en-US" sz="800" dirty="0" smtClean="0">
                  <a:latin typeface="Arial"/>
                  <a:cs typeface="Arial"/>
                </a:rPr>
                <a:t>MEK1 p</a:t>
              </a:r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lasmid tagged with GFP</a:t>
              </a:r>
              <a:endParaRPr lang="en-US" sz="8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2790851" y="3084395"/>
              <a:ext cx="3562299" cy="2045424"/>
              <a:chOff x="3113694" y="1741702"/>
              <a:chExt cx="3562299" cy="2045424"/>
            </a:xfrm>
          </p:grpSpPr>
          <p:sp>
            <p:nvSpPr>
              <p:cNvPr id="17" name="TextBox 16"/>
              <p:cNvSpPr txBox="1"/>
              <p:nvPr/>
            </p:nvSpPr>
            <p:spPr>
              <a:xfrm rot="19260597">
                <a:off x="3113694" y="1871865"/>
                <a:ext cx="13688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M</a:t>
                </a:r>
                <a:r>
                  <a:rPr lang="en-US" sz="1000" b="1" dirty="0" smtClean="0"/>
                  <a:t>ock</a:t>
                </a:r>
                <a:endParaRPr lang="en-US" sz="10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9260597">
                <a:off x="3498239" y="1864260"/>
                <a:ext cx="13688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0000"/>
                    </a:solidFill>
                  </a:rPr>
                  <a:t>MAP2K1 </a:t>
                </a:r>
                <a:endParaRPr lang="en-US" sz="1000" b="1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9260597">
                <a:off x="3837235" y="1879770"/>
                <a:ext cx="13688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0000"/>
                    </a:solidFill>
                  </a:rPr>
                  <a:t>MAP2K1 F53L</a:t>
                </a:r>
                <a:endParaRPr lang="en-US" sz="1000" b="1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9260597">
                <a:off x="4135802" y="1742035"/>
                <a:ext cx="1782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0000"/>
                    </a:solidFill>
                  </a:rPr>
                  <a:t>MAP2K1 Q56P</a:t>
                </a:r>
                <a:endParaRPr lang="en-US" sz="1000" b="1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9260597">
                <a:off x="4503631" y="1741702"/>
                <a:ext cx="1782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0000"/>
                    </a:solidFill>
                  </a:rPr>
                  <a:t>MAP2K1 K57N</a:t>
                </a:r>
                <a:endParaRPr lang="en-US" sz="1000" b="1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9260597">
                <a:off x="4865032" y="1743618"/>
                <a:ext cx="1782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00FF"/>
                    </a:solidFill>
                  </a:rPr>
                  <a:t>MAP2K1 A106T</a:t>
                </a:r>
                <a:endParaRPr lang="en-US" sz="1000" b="1" dirty="0">
                  <a:solidFill>
                    <a:srgbClr val="0000FF"/>
                  </a:solidFill>
                </a:endParaRPr>
              </a:p>
            </p:txBody>
          </p:sp>
          <p:grpSp>
            <p:nvGrpSpPr>
              <p:cNvPr id="23" name="Group 22"/>
              <p:cNvGrpSpPr/>
              <p:nvPr/>
            </p:nvGrpSpPr>
            <p:grpSpPr>
              <a:xfrm>
                <a:off x="3128266" y="2475107"/>
                <a:ext cx="3547727" cy="1312019"/>
                <a:chOff x="3128266" y="3177838"/>
                <a:chExt cx="3547727" cy="1312019"/>
              </a:xfrm>
            </p:grpSpPr>
            <p:sp>
              <p:nvSpPr>
                <p:cNvPr id="24" name="TextBox 23"/>
                <p:cNvSpPr txBox="1"/>
                <p:nvPr/>
              </p:nvSpPr>
              <p:spPr>
                <a:xfrm>
                  <a:off x="5379331" y="3224059"/>
                  <a:ext cx="12966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solidFill>
                        <a:srgbClr val="000000"/>
                      </a:solidFill>
                    </a:rPr>
                    <a:t>p-ERK (S202/T204)</a:t>
                  </a:r>
                  <a:endParaRPr lang="en-US" sz="1000" b="1" dirty="0"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5387632" y="3540905"/>
                  <a:ext cx="9906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solidFill>
                        <a:srgbClr val="000000"/>
                      </a:solidFill>
                    </a:rPr>
                    <a:t>ERK</a:t>
                  </a:r>
                  <a:endParaRPr lang="en-US" sz="1000" b="1" dirty="0"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5386010" y="3843046"/>
                  <a:ext cx="9906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solidFill>
                        <a:srgbClr val="000000"/>
                      </a:solidFill>
                    </a:rPr>
                    <a:t>GFP</a:t>
                  </a:r>
                  <a:r>
                    <a:rPr lang="en-US" sz="1000" dirty="0">
                      <a:solidFill>
                        <a:srgbClr val="FF0000"/>
                      </a:solidFill>
                    </a:rPr>
                    <a:t>*</a:t>
                  </a:r>
                  <a:endParaRPr lang="en-US" sz="10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5386310" y="4206522"/>
                  <a:ext cx="9906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solidFill>
                        <a:srgbClr val="000000"/>
                      </a:solidFill>
                    </a:rPr>
                    <a:t>GAPDH</a:t>
                  </a:r>
                  <a:endParaRPr lang="en-US" sz="1000" b="1" dirty="0">
                    <a:solidFill>
                      <a:srgbClr val="FF0000"/>
                    </a:solidFill>
                  </a:endParaRPr>
                </a:p>
              </p:txBody>
            </p:sp>
            <p:pic>
              <p:nvPicPr>
                <p:cNvPr id="28" name="Picture 27" descr="p-ERK.png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143" t="35628" r="40148" b="59381"/>
                <a:stretch/>
              </p:blipFill>
              <p:spPr>
                <a:xfrm>
                  <a:off x="3128267" y="3177838"/>
                  <a:ext cx="2259366" cy="31801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9" name="Picture 28" descr="ERK.png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305" t="58324" r="41078" b="37171"/>
                <a:stretch/>
              </p:blipFill>
              <p:spPr>
                <a:xfrm>
                  <a:off x="3128266" y="3528627"/>
                  <a:ext cx="2259367" cy="289790"/>
                </a:xfrm>
                <a:prstGeom prst="rect">
                  <a:avLst/>
                </a:prstGeom>
                <a:ln>
                  <a:solidFill>
                    <a:srgbClr val="000000"/>
                  </a:solidFill>
                </a:ln>
              </p:spPr>
            </p:pic>
            <p:pic>
              <p:nvPicPr>
                <p:cNvPr id="30" name="Picture 29" descr="GFP.png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143" t="54257" r="40148" b="41468"/>
                <a:stretch/>
              </p:blipFill>
              <p:spPr>
                <a:xfrm>
                  <a:off x="3128266" y="3851569"/>
                  <a:ext cx="2259367" cy="271790"/>
                </a:xfrm>
                <a:prstGeom prst="rect">
                  <a:avLst/>
                </a:prstGeom>
                <a:ln>
                  <a:solidFill>
                    <a:srgbClr val="000000"/>
                  </a:solidFill>
                </a:ln>
              </p:spPr>
            </p:pic>
            <p:pic>
              <p:nvPicPr>
                <p:cNvPr id="31" name="Picture 30" descr="20140408_1345.tif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220" t="53312" r="48162" b="41235"/>
                <a:stretch/>
              </p:blipFill>
              <p:spPr>
                <a:xfrm>
                  <a:off x="3128266" y="4157451"/>
                  <a:ext cx="2251065" cy="332406"/>
                </a:xfrm>
                <a:prstGeom prst="rect">
                  <a:avLst/>
                </a:prstGeom>
                <a:ln>
                  <a:solidFill>
                    <a:srgbClr val="000000"/>
                  </a:solidFill>
                </a:ln>
              </p:spPr>
            </p:pic>
          </p:grpSp>
        </p:grpSp>
      </p:grpSp>
    </p:spTree>
    <p:extLst>
      <p:ext uri="{BB962C8B-B14F-4D97-AF65-F5344CB8AC3E}">
        <p14:creationId xmlns:p14="http://schemas.microsoft.com/office/powerpoint/2010/main" val="140119855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760" y="5080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53119" y="4320944"/>
            <a:ext cx="5994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rvival difference based on mutational concordance.</a:t>
            </a:r>
            <a:endParaRPr lang="en-US" sz="1400" b="1" dirty="0" smtClean="0"/>
          </a:p>
          <a:p>
            <a:r>
              <a:rPr lang="en-US" sz="1400" dirty="0" smtClean="0"/>
              <a:t>There is no survival difference between patients with concordant and discordant primary and metastatic tumors.  </a:t>
            </a:r>
            <a:endParaRPr lang="en-US" sz="1400" dirty="0"/>
          </a:p>
        </p:txBody>
      </p:sp>
      <p:pic>
        <p:nvPicPr>
          <p:cNvPr id="2" name="Picture 1" descr="Concordance_K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688" y="606014"/>
            <a:ext cx="3575012" cy="357501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79600" y="3726934"/>
            <a:ext cx="1435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onths </a:t>
            </a:r>
            <a:r>
              <a:rPr lang="en-US" sz="1400" dirty="0" err="1" smtClean="0"/>
              <a:t>followup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3891296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760" y="5080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6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11760" y="37823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3765" y="474649"/>
            <a:ext cx="2460748" cy="1587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6" descr="Screen Shot 2013-10-02 at 5.49.44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50"/>
          <a:stretch/>
        </p:blipFill>
        <p:spPr>
          <a:xfrm>
            <a:off x="3295341" y="472307"/>
            <a:ext cx="2865981" cy="811363"/>
          </a:xfrm>
          <a:prstGeom prst="rect">
            <a:avLst/>
          </a:prstGeom>
        </p:spPr>
      </p:pic>
      <p:pic>
        <p:nvPicPr>
          <p:cNvPr id="12" name="Picture 11" descr="Screen Shot 2013-10-02 at 5.54.02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764" y="1276068"/>
            <a:ext cx="2886558" cy="824731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2961858" y="4746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5959" y="23265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80221" y="4051852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3073767" y="4051852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1760" y="6045689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3100693" y="2231590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163750" y="5995210"/>
            <a:ext cx="328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pic>
        <p:nvPicPr>
          <p:cNvPr id="42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4324" y="4192958"/>
            <a:ext cx="2709443" cy="1747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3" name="Picture 42" descr="Screen Shot 2013-10-02 at 6.23.11 PM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067" y="5035305"/>
            <a:ext cx="2886558" cy="841328"/>
          </a:xfrm>
          <a:prstGeom prst="rect">
            <a:avLst/>
          </a:prstGeom>
        </p:spPr>
      </p:pic>
      <p:pic>
        <p:nvPicPr>
          <p:cNvPr id="45" name="Picture 44" descr="Screen Shot 2013-10-02 at 6.24.54 PM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341" y="4200796"/>
            <a:ext cx="2852594" cy="82096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4324" y="2357281"/>
            <a:ext cx="2345009" cy="140700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2900" y="6287966"/>
            <a:ext cx="2561613" cy="132200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81039" y="2338905"/>
            <a:ext cx="2350607" cy="1600635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09550" y="8026391"/>
            <a:ext cx="635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Whole genome sequencing shows that IMPACT results predict for concordance or discordance at the larger genome level.  </a:t>
            </a:r>
            <a:r>
              <a:rPr lang="en-US" sz="1200" dirty="0" smtClean="0"/>
              <a:t>Patient 54 (A-D) is completely concordant at the mutation (A) and copy number level (B) by IMPACT, and WGS shows a high degree of concordance (C) with all nonsense and splice site mutations in both primary and metastasis (D, red dots). Patient 19 (E-H) was discordant by IMPACT (E-F) and showed tremendous discordance at the whole genome level (G-H).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92235" y="6045689"/>
            <a:ext cx="2404271" cy="16371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9530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90</TotalTime>
  <Words>345</Words>
  <Application>Microsoft Macintosh PowerPoint</Application>
  <PresentationFormat>Letter Paper (8.5x11 in)</PresentationFormat>
  <Paragraphs>39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SK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nnon, Angela R./Sloan-Kettering Institute</dc:creator>
  <cp:lastModifiedBy>Brannon, Angela R./Sloan-Kettering Institute</cp:lastModifiedBy>
  <cp:revision>6</cp:revision>
  <dcterms:created xsi:type="dcterms:W3CDTF">2014-04-14T02:27:59Z</dcterms:created>
  <dcterms:modified xsi:type="dcterms:W3CDTF">2014-06-24T23:27:58Z</dcterms:modified>
</cp:coreProperties>
</file>